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9" r:id="rId4"/>
    <p:sldId id="260" r:id="rId5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24" autoAdjust="0"/>
  </p:normalViewPr>
  <p:slideViewPr>
    <p:cSldViewPr>
      <p:cViewPr>
        <p:scale>
          <a:sx n="100" d="100"/>
          <a:sy n="100" d="100"/>
        </p:scale>
        <p:origin x="-30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534364-C0C5-4479-B752-C42664D67F87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186F06-FD34-442C-97A6-7384506D90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1303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186F06-FD34-442C-97A6-7384506D9010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20967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4662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8654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6284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4775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3839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0305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6885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5057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5883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8287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6185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91D731-5859-4932-98AB-00A85F1D8D11}" type="datetimeFigureOut">
              <a:rPr lang="de-DE" smtClean="0"/>
              <a:t>26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57BA8-15BE-4FD7-8808-4D047E1C7A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1157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image" Target="../media/image23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12" Type="http://schemas.openxmlformats.org/officeDocument/2006/relationships/image" Target="../media/image2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emf"/><Relationship Id="rId11" Type="http://schemas.openxmlformats.org/officeDocument/2006/relationships/image" Target="../media/image21.emf"/><Relationship Id="rId5" Type="http://schemas.openxmlformats.org/officeDocument/2006/relationships/image" Target="../media/image15.emf"/><Relationship Id="rId10" Type="http://schemas.openxmlformats.org/officeDocument/2006/relationships/image" Target="../media/image20.emf"/><Relationship Id="rId4" Type="http://schemas.openxmlformats.org/officeDocument/2006/relationships/image" Target="../media/image14.emf"/><Relationship Id="rId9" Type="http://schemas.openxmlformats.org/officeDocument/2006/relationships/image" Target="../media/image19.emf"/><Relationship Id="rId14" Type="http://schemas.openxmlformats.org/officeDocument/2006/relationships/image" Target="../media/image2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12" Type="http://schemas.openxmlformats.org/officeDocument/2006/relationships/image" Target="../media/image35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5" Type="http://schemas.openxmlformats.org/officeDocument/2006/relationships/image" Target="../media/image28.emf"/><Relationship Id="rId10" Type="http://schemas.openxmlformats.org/officeDocument/2006/relationships/image" Target="../media/image33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0" name="Picture 8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431"/>
          <a:stretch/>
        </p:blipFill>
        <p:spPr bwMode="auto">
          <a:xfrm>
            <a:off x="4800177" y="2662523"/>
            <a:ext cx="1774967" cy="1112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04" name="Gruppieren 303"/>
          <p:cNvGrpSpPr/>
          <p:nvPr/>
        </p:nvGrpSpPr>
        <p:grpSpPr>
          <a:xfrm>
            <a:off x="3117364" y="1155279"/>
            <a:ext cx="348714" cy="88181"/>
            <a:chOff x="1447800" y="457200"/>
            <a:chExt cx="383732" cy="64279"/>
          </a:xfrm>
        </p:grpSpPr>
        <p:cxnSp>
          <p:nvCxnSpPr>
            <p:cNvPr id="305" name="Gerade Verbindung 304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Gerade Verbindung 305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Gerade Verbindung 30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8" name="Textfeld 307"/>
          <p:cNvSpPr txBox="1"/>
          <p:nvPr/>
        </p:nvSpPr>
        <p:spPr>
          <a:xfrm>
            <a:off x="3165132" y="1035085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9" name="Gruppieren 308"/>
          <p:cNvGrpSpPr/>
          <p:nvPr/>
        </p:nvGrpSpPr>
        <p:grpSpPr>
          <a:xfrm>
            <a:off x="3117364" y="960327"/>
            <a:ext cx="674709" cy="86293"/>
            <a:chOff x="1447800" y="457200"/>
            <a:chExt cx="383732" cy="55500"/>
          </a:xfrm>
        </p:grpSpPr>
        <p:cxnSp>
          <p:nvCxnSpPr>
            <p:cNvPr id="310" name="Gerade Verbindung 309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Gerade Verbindung 310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Gerade Verbindung 31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3" name="Textfeld 312"/>
          <p:cNvSpPr txBox="1"/>
          <p:nvPr/>
        </p:nvSpPr>
        <p:spPr>
          <a:xfrm>
            <a:off x="3345016" y="833781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14" name="Gruppieren 313"/>
          <p:cNvGrpSpPr/>
          <p:nvPr/>
        </p:nvGrpSpPr>
        <p:grpSpPr>
          <a:xfrm>
            <a:off x="3114395" y="745355"/>
            <a:ext cx="1022350" cy="87657"/>
            <a:chOff x="1447800" y="457200"/>
            <a:chExt cx="382775" cy="78771"/>
          </a:xfrm>
        </p:grpSpPr>
        <p:cxnSp>
          <p:nvCxnSpPr>
            <p:cNvPr id="315" name="Gerade Verbindung 314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Gerade Verbindung 315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Gerade Verbindung 31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8" name="Textfeld 317"/>
          <p:cNvSpPr txBox="1"/>
          <p:nvPr/>
        </p:nvSpPr>
        <p:spPr>
          <a:xfrm>
            <a:off x="3444595" y="61200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20" name="Gruppieren 319"/>
          <p:cNvGrpSpPr/>
          <p:nvPr/>
        </p:nvGrpSpPr>
        <p:grpSpPr>
          <a:xfrm>
            <a:off x="3462036" y="591061"/>
            <a:ext cx="674709" cy="86293"/>
            <a:chOff x="1447800" y="457200"/>
            <a:chExt cx="383732" cy="55500"/>
          </a:xfrm>
        </p:grpSpPr>
        <p:cxnSp>
          <p:nvCxnSpPr>
            <p:cNvPr id="321" name="Gerade Verbindung 320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Gerade Verbindung 321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Gerade Verbindung 32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4" name="Textfeld 323"/>
          <p:cNvSpPr txBox="1"/>
          <p:nvPr/>
        </p:nvSpPr>
        <p:spPr>
          <a:xfrm>
            <a:off x="3697003" y="46451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5" name="Textfeld 344"/>
          <p:cNvSpPr txBox="1"/>
          <p:nvPr/>
        </p:nvSpPr>
        <p:spPr>
          <a:xfrm>
            <a:off x="4913375" y="312115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Efcab4a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46" name="Gruppieren 345"/>
          <p:cNvGrpSpPr/>
          <p:nvPr/>
        </p:nvGrpSpPr>
        <p:grpSpPr>
          <a:xfrm>
            <a:off x="5334005" y="1143699"/>
            <a:ext cx="348714" cy="88181"/>
            <a:chOff x="1447800" y="457200"/>
            <a:chExt cx="383732" cy="64279"/>
          </a:xfrm>
        </p:grpSpPr>
        <p:cxnSp>
          <p:nvCxnSpPr>
            <p:cNvPr id="347" name="Gerade Verbindung 346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Gerade Verbindung 347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9" name="Gerade Verbindung 34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0" name="Textfeld 349"/>
          <p:cNvSpPr txBox="1"/>
          <p:nvPr/>
        </p:nvSpPr>
        <p:spPr>
          <a:xfrm>
            <a:off x="5352513" y="1023505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51" name="Gruppieren 350"/>
          <p:cNvGrpSpPr/>
          <p:nvPr/>
        </p:nvGrpSpPr>
        <p:grpSpPr>
          <a:xfrm>
            <a:off x="5334005" y="991563"/>
            <a:ext cx="674709" cy="86293"/>
            <a:chOff x="1447800" y="457200"/>
            <a:chExt cx="383732" cy="55500"/>
          </a:xfrm>
        </p:grpSpPr>
        <p:cxnSp>
          <p:nvCxnSpPr>
            <p:cNvPr id="352" name="Gerade Verbindung 351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3" name="Gerade Verbindung 352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Gerade Verbindung 35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5" name="Textfeld 354"/>
          <p:cNvSpPr txBox="1"/>
          <p:nvPr/>
        </p:nvSpPr>
        <p:spPr>
          <a:xfrm>
            <a:off x="5532397" y="865017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6" name="Textfeld 355"/>
          <p:cNvSpPr txBox="1"/>
          <p:nvPr/>
        </p:nvSpPr>
        <p:spPr>
          <a:xfrm>
            <a:off x="5661236" y="517401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57" name="Gruppieren 356"/>
          <p:cNvGrpSpPr/>
          <p:nvPr/>
        </p:nvGrpSpPr>
        <p:grpSpPr>
          <a:xfrm>
            <a:off x="5331509" y="652656"/>
            <a:ext cx="1017609" cy="87657"/>
            <a:chOff x="1447800" y="457200"/>
            <a:chExt cx="381000" cy="78771"/>
          </a:xfrm>
        </p:grpSpPr>
        <p:cxnSp>
          <p:nvCxnSpPr>
            <p:cNvPr id="358" name="Gerade Verbindung 357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Gerade Verbindung 358"/>
            <p:cNvCxnSpPr/>
            <p:nvPr/>
          </p:nvCxnSpPr>
          <p:spPr>
            <a:xfrm>
              <a:off x="1826594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Gerade Verbindung 35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2" name="Gruppieren 361"/>
          <p:cNvGrpSpPr/>
          <p:nvPr/>
        </p:nvGrpSpPr>
        <p:grpSpPr>
          <a:xfrm>
            <a:off x="5675375" y="485601"/>
            <a:ext cx="674709" cy="86293"/>
            <a:chOff x="1447800" y="457200"/>
            <a:chExt cx="383732" cy="55500"/>
          </a:xfrm>
        </p:grpSpPr>
        <p:cxnSp>
          <p:nvCxnSpPr>
            <p:cNvPr id="363" name="Gerade Verbindung 362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Gerade Verbindung 363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Gerade Verbindung 364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6" name="Textfeld 365"/>
          <p:cNvSpPr txBox="1"/>
          <p:nvPr/>
        </p:nvSpPr>
        <p:spPr>
          <a:xfrm>
            <a:off x="5903027" y="35905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3" name="Textfeld 402"/>
          <p:cNvSpPr txBox="1"/>
          <p:nvPr/>
        </p:nvSpPr>
        <p:spPr>
          <a:xfrm>
            <a:off x="7109479" y="312115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Drd4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20" name="Gruppieren 419"/>
          <p:cNvGrpSpPr/>
          <p:nvPr/>
        </p:nvGrpSpPr>
        <p:grpSpPr>
          <a:xfrm>
            <a:off x="7531783" y="1069100"/>
            <a:ext cx="348714" cy="88181"/>
            <a:chOff x="1447800" y="457200"/>
            <a:chExt cx="383732" cy="64279"/>
          </a:xfrm>
        </p:grpSpPr>
        <p:cxnSp>
          <p:nvCxnSpPr>
            <p:cNvPr id="421" name="Gerade Verbindung 420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2" name="Gerade Verbindung 421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3" name="Gerade Verbindung 42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4" name="Textfeld 423"/>
          <p:cNvSpPr txBox="1"/>
          <p:nvPr/>
        </p:nvSpPr>
        <p:spPr>
          <a:xfrm>
            <a:off x="7560061" y="948906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25" name="Gruppieren 424"/>
          <p:cNvGrpSpPr/>
          <p:nvPr/>
        </p:nvGrpSpPr>
        <p:grpSpPr>
          <a:xfrm>
            <a:off x="7533862" y="899263"/>
            <a:ext cx="669905" cy="86293"/>
            <a:chOff x="1447800" y="457200"/>
            <a:chExt cx="381000" cy="55500"/>
          </a:xfrm>
        </p:grpSpPr>
        <p:cxnSp>
          <p:nvCxnSpPr>
            <p:cNvPr id="426" name="Gerade Verbindung 425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7" name="Gerade Verbindung 426"/>
            <p:cNvCxnSpPr/>
            <p:nvPr/>
          </p:nvCxnSpPr>
          <p:spPr>
            <a:xfrm>
              <a:off x="182737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8" name="Gerade Verbindung 427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9" name="Textfeld 428"/>
          <p:cNvSpPr txBox="1"/>
          <p:nvPr/>
        </p:nvSpPr>
        <p:spPr>
          <a:xfrm>
            <a:off x="7713747" y="772717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0" name="Textfeld 429"/>
          <p:cNvSpPr txBox="1"/>
          <p:nvPr/>
        </p:nvSpPr>
        <p:spPr>
          <a:xfrm>
            <a:off x="7856406" y="586379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31" name="Gruppieren 430"/>
          <p:cNvGrpSpPr/>
          <p:nvPr/>
        </p:nvGrpSpPr>
        <p:grpSpPr>
          <a:xfrm>
            <a:off x="7526680" y="721634"/>
            <a:ext cx="1022350" cy="87657"/>
            <a:chOff x="1447800" y="457200"/>
            <a:chExt cx="382775" cy="78771"/>
          </a:xfrm>
        </p:grpSpPr>
        <p:cxnSp>
          <p:nvCxnSpPr>
            <p:cNvPr id="432" name="Gerade Verbindung 431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3" name="Gerade Verbindung 432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4" name="Gerade Verbindung 43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5" name="Textfeld 484"/>
          <p:cNvSpPr txBox="1"/>
          <p:nvPr/>
        </p:nvSpPr>
        <p:spPr>
          <a:xfrm>
            <a:off x="3132634" y="3128055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86" name="Gruppieren 485"/>
          <p:cNvGrpSpPr/>
          <p:nvPr/>
        </p:nvGrpSpPr>
        <p:grpSpPr>
          <a:xfrm>
            <a:off x="3114395" y="3262255"/>
            <a:ext cx="348714" cy="88181"/>
            <a:chOff x="1447800" y="457200"/>
            <a:chExt cx="383732" cy="64279"/>
          </a:xfrm>
        </p:grpSpPr>
        <p:cxnSp>
          <p:nvCxnSpPr>
            <p:cNvPr id="487" name="Gerade Verbindung 486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8" name="Gerade Verbindung 487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9" name="Gerade Verbindung 48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0" name="Gruppieren 489"/>
          <p:cNvGrpSpPr/>
          <p:nvPr/>
        </p:nvGrpSpPr>
        <p:grpSpPr>
          <a:xfrm>
            <a:off x="3114395" y="3080935"/>
            <a:ext cx="674709" cy="86293"/>
            <a:chOff x="1447800" y="457200"/>
            <a:chExt cx="383732" cy="55500"/>
          </a:xfrm>
        </p:grpSpPr>
        <p:cxnSp>
          <p:nvCxnSpPr>
            <p:cNvPr id="491" name="Gerade Verbindung 490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2" name="Gerade Verbindung 491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3" name="Gerade Verbindung 49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4" name="Textfeld 493"/>
          <p:cNvSpPr txBox="1"/>
          <p:nvPr/>
        </p:nvSpPr>
        <p:spPr>
          <a:xfrm>
            <a:off x="3294279" y="2954389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5" name="Textfeld 494"/>
          <p:cNvSpPr txBox="1"/>
          <p:nvPr/>
        </p:nvSpPr>
        <p:spPr>
          <a:xfrm>
            <a:off x="3444121" y="276514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96" name="Gruppieren 495"/>
          <p:cNvGrpSpPr/>
          <p:nvPr/>
        </p:nvGrpSpPr>
        <p:grpSpPr>
          <a:xfrm>
            <a:off x="3114395" y="2900400"/>
            <a:ext cx="1022350" cy="87657"/>
            <a:chOff x="1447800" y="457200"/>
            <a:chExt cx="382775" cy="78771"/>
          </a:xfrm>
        </p:grpSpPr>
        <p:cxnSp>
          <p:nvCxnSpPr>
            <p:cNvPr id="497" name="Gerade Verbindung 496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8" name="Gerade Verbindung 497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9" name="Gerade Verbindung 49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0" name="Textfeld 499"/>
          <p:cNvSpPr txBox="1"/>
          <p:nvPr/>
        </p:nvSpPr>
        <p:spPr>
          <a:xfrm>
            <a:off x="2723181" y="2433313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Adam11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1" name="Textfeld 500"/>
          <p:cNvSpPr txBox="1"/>
          <p:nvPr/>
        </p:nvSpPr>
        <p:spPr>
          <a:xfrm>
            <a:off x="5348194" y="3163563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02" name="Gruppieren 501"/>
          <p:cNvGrpSpPr/>
          <p:nvPr/>
        </p:nvGrpSpPr>
        <p:grpSpPr>
          <a:xfrm>
            <a:off x="5329955" y="3292607"/>
            <a:ext cx="348714" cy="88181"/>
            <a:chOff x="1447800" y="457200"/>
            <a:chExt cx="383732" cy="64279"/>
          </a:xfrm>
        </p:grpSpPr>
        <p:cxnSp>
          <p:nvCxnSpPr>
            <p:cNvPr id="503" name="Gerade Verbindung 502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4" name="Gerade Verbindung 503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5" name="Gerade Verbindung 504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6" name="Gruppieren 505"/>
          <p:cNvGrpSpPr/>
          <p:nvPr/>
        </p:nvGrpSpPr>
        <p:grpSpPr>
          <a:xfrm>
            <a:off x="5330866" y="3105223"/>
            <a:ext cx="674709" cy="86293"/>
            <a:chOff x="1447800" y="457200"/>
            <a:chExt cx="383732" cy="55500"/>
          </a:xfrm>
        </p:grpSpPr>
        <p:cxnSp>
          <p:nvCxnSpPr>
            <p:cNvPr id="507" name="Gerade Verbindung 506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8" name="Gerade Verbindung 507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9" name="Gerade Verbindung 50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0" name="Textfeld 509"/>
          <p:cNvSpPr txBox="1"/>
          <p:nvPr/>
        </p:nvSpPr>
        <p:spPr>
          <a:xfrm>
            <a:off x="5535410" y="297651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1" name="Textfeld 510"/>
          <p:cNvSpPr txBox="1"/>
          <p:nvPr/>
        </p:nvSpPr>
        <p:spPr>
          <a:xfrm>
            <a:off x="5713916" y="279046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2" name="Gruppieren 511"/>
          <p:cNvGrpSpPr/>
          <p:nvPr/>
        </p:nvGrpSpPr>
        <p:grpSpPr>
          <a:xfrm>
            <a:off x="5338825" y="2929782"/>
            <a:ext cx="1022350" cy="87657"/>
            <a:chOff x="1447800" y="457200"/>
            <a:chExt cx="382775" cy="78771"/>
          </a:xfrm>
        </p:grpSpPr>
        <p:cxnSp>
          <p:nvCxnSpPr>
            <p:cNvPr id="513" name="Gerade Verbindung 512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4" name="Gerade Verbindung 513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5" name="Gerade Verbindung 514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6" name="Textfeld 515"/>
          <p:cNvSpPr txBox="1"/>
          <p:nvPr/>
        </p:nvSpPr>
        <p:spPr>
          <a:xfrm>
            <a:off x="4913375" y="2433313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Fosb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7" name="Textfeld 516"/>
          <p:cNvSpPr txBox="1"/>
          <p:nvPr/>
        </p:nvSpPr>
        <p:spPr>
          <a:xfrm>
            <a:off x="7566834" y="3244234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8" name="Gruppieren 517"/>
          <p:cNvGrpSpPr/>
          <p:nvPr/>
        </p:nvGrpSpPr>
        <p:grpSpPr>
          <a:xfrm>
            <a:off x="7538802" y="3363972"/>
            <a:ext cx="347749" cy="88181"/>
            <a:chOff x="1447800" y="457200"/>
            <a:chExt cx="382670" cy="64279"/>
          </a:xfrm>
        </p:grpSpPr>
        <p:cxnSp>
          <p:nvCxnSpPr>
            <p:cNvPr id="519" name="Gerade Verbindung 51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0" name="Gerade Verbindung 519"/>
            <p:cNvCxnSpPr/>
            <p:nvPr/>
          </p:nvCxnSpPr>
          <p:spPr>
            <a:xfrm>
              <a:off x="1830470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1" name="Gerade Verbindung 52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22" name="Gerade Verbindung 521"/>
          <p:cNvCxnSpPr/>
          <p:nvPr/>
        </p:nvCxnSpPr>
        <p:spPr>
          <a:xfrm>
            <a:off x="7540261" y="3154424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3" name="Gerade Verbindung 522"/>
          <p:cNvCxnSpPr/>
          <p:nvPr/>
        </p:nvCxnSpPr>
        <p:spPr>
          <a:xfrm>
            <a:off x="8214970" y="3158421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4" name="Gerade Verbindung 523"/>
          <p:cNvCxnSpPr/>
          <p:nvPr/>
        </p:nvCxnSpPr>
        <p:spPr>
          <a:xfrm flipH="1">
            <a:off x="7540261" y="3154424"/>
            <a:ext cx="66990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5" name="Textfeld 524"/>
          <p:cNvSpPr txBox="1"/>
          <p:nvPr/>
        </p:nvSpPr>
        <p:spPr>
          <a:xfrm>
            <a:off x="7720145" y="302787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6" name="Textfeld 525"/>
          <p:cNvSpPr txBox="1"/>
          <p:nvPr/>
        </p:nvSpPr>
        <p:spPr>
          <a:xfrm>
            <a:off x="7871596" y="2799278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27" name="Gruppieren 526"/>
          <p:cNvGrpSpPr/>
          <p:nvPr/>
        </p:nvGrpSpPr>
        <p:grpSpPr>
          <a:xfrm>
            <a:off x="7541870" y="2934533"/>
            <a:ext cx="1022350" cy="87657"/>
            <a:chOff x="1447800" y="457200"/>
            <a:chExt cx="382775" cy="78771"/>
          </a:xfrm>
        </p:grpSpPr>
        <p:cxnSp>
          <p:nvCxnSpPr>
            <p:cNvPr id="528" name="Gerade Verbindung 527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9" name="Gerade Verbindung 528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0" name="Gerade Verbindung 52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1" name="Gruppieren 530"/>
          <p:cNvGrpSpPr/>
          <p:nvPr/>
        </p:nvGrpSpPr>
        <p:grpSpPr>
          <a:xfrm>
            <a:off x="7891656" y="2723078"/>
            <a:ext cx="348714" cy="88181"/>
            <a:chOff x="1447800" y="457200"/>
            <a:chExt cx="383732" cy="64279"/>
          </a:xfrm>
        </p:grpSpPr>
        <p:cxnSp>
          <p:nvCxnSpPr>
            <p:cNvPr id="532" name="Gerade Verbindung 531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3" name="Gerade Verbindung 532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4" name="Gerade Verbindung 53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5" name="Textfeld 534"/>
          <p:cNvSpPr txBox="1"/>
          <p:nvPr/>
        </p:nvSpPr>
        <p:spPr>
          <a:xfrm>
            <a:off x="7948745" y="260242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36" name="Gruppieren 535"/>
          <p:cNvGrpSpPr/>
          <p:nvPr/>
        </p:nvGrpSpPr>
        <p:grpSpPr>
          <a:xfrm>
            <a:off x="7889511" y="2544824"/>
            <a:ext cx="674709" cy="86293"/>
            <a:chOff x="1447800" y="457200"/>
            <a:chExt cx="383732" cy="55500"/>
          </a:xfrm>
        </p:grpSpPr>
        <p:cxnSp>
          <p:nvCxnSpPr>
            <p:cNvPr id="537" name="Gerade Verbindung 536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8" name="Gerade Verbindung 537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9" name="Gerade Verbindung 53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0" name="Textfeld 539"/>
          <p:cNvSpPr txBox="1"/>
          <p:nvPr/>
        </p:nvSpPr>
        <p:spPr>
          <a:xfrm>
            <a:off x="8088445" y="241827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41" name="Gruppieren 540"/>
          <p:cNvGrpSpPr/>
          <p:nvPr/>
        </p:nvGrpSpPr>
        <p:grpSpPr>
          <a:xfrm>
            <a:off x="8234081" y="2335728"/>
            <a:ext cx="348714" cy="88181"/>
            <a:chOff x="1447800" y="457200"/>
            <a:chExt cx="383732" cy="64279"/>
          </a:xfrm>
        </p:grpSpPr>
        <p:cxnSp>
          <p:nvCxnSpPr>
            <p:cNvPr id="542" name="Gerade Verbindung 541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3" name="Gerade Verbindung 542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4" name="Gerade Verbindung 54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5" name="Textfeld 544"/>
          <p:cNvSpPr txBox="1"/>
          <p:nvPr/>
        </p:nvSpPr>
        <p:spPr>
          <a:xfrm>
            <a:off x="8291170" y="221507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6" name="Textfeld 545"/>
          <p:cNvSpPr txBox="1"/>
          <p:nvPr/>
        </p:nvSpPr>
        <p:spPr>
          <a:xfrm>
            <a:off x="6854671" y="2416061"/>
            <a:ext cx="147700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Chr1:107998952-108000925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  <a:p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3" name="Textfeld 612"/>
          <p:cNvSpPr txBox="1"/>
          <p:nvPr/>
        </p:nvSpPr>
        <p:spPr>
          <a:xfrm>
            <a:off x="2691563" y="4554511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Cdh15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14" name="Gruppieren 613"/>
          <p:cNvGrpSpPr/>
          <p:nvPr/>
        </p:nvGrpSpPr>
        <p:grpSpPr>
          <a:xfrm>
            <a:off x="3133858" y="5250675"/>
            <a:ext cx="348714" cy="87768"/>
            <a:chOff x="1447800" y="457200"/>
            <a:chExt cx="383732" cy="63978"/>
          </a:xfrm>
        </p:grpSpPr>
        <p:cxnSp>
          <p:nvCxnSpPr>
            <p:cNvPr id="615" name="Gerade Verbindung 614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6" name="Gerade Verbindung 615"/>
            <p:cNvCxnSpPr/>
            <p:nvPr/>
          </p:nvCxnSpPr>
          <p:spPr>
            <a:xfrm>
              <a:off x="1831532" y="45947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7" name="Gerade Verbindung 61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8" name="Textfeld 617"/>
          <p:cNvSpPr txBox="1"/>
          <p:nvPr/>
        </p:nvSpPr>
        <p:spPr>
          <a:xfrm>
            <a:off x="3150970" y="5117326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19" name="Gruppieren 618"/>
          <p:cNvGrpSpPr/>
          <p:nvPr/>
        </p:nvGrpSpPr>
        <p:grpSpPr>
          <a:xfrm>
            <a:off x="3131712" y="5097822"/>
            <a:ext cx="674709" cy="86293"/>
            <a:chOff x="2868920" y="5536746"/>
            <a:chExt cx="674709" cy="86293"/>
          </a:xfrm>
        </p:grpSpPr>
        <p:cxnSp>
          <p:nvCxnSpPr>
            <p:cNvPr id="620" name="Gerade Verbindung 619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1" name="Gerade Verbindung 620"/>
            <p:cNvCxnSpPr/>
            <p:nvPr/>
          </p:nvCxnSpPr>
          <p:spPr>
            <a:xfrm>
              <a:off x="3543629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2" name="Gerade Verbindung 621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3" name="Textfeld 622"/>
          <p:cNvSpPr txBox="1"/>
          <p:nvPr/>
        </p:nvSpPr>
        <p:spPr>
          <a:xfrm>
            <a:off x="3311596" y="4971276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4" name="Textfeld 623"/>
          <p:cNvSpPr txBox="1"/>
          <p:nvPr/>
        </p:nvSpPr>
        <p:spPr>
          <a:xfrm>
            <a:off x="3454331" y="4793476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25" name="Gruppieren 624"/>
          <p:cNvGrpSpPr/>
          <p:nvPr/>
        </p:nvGrpSpPr>
        <p:grpSpPr>
          <a:xfrm>
            <a:off x="3136337" y="4928731"/>
            <a:ext cx="1017609" cy="87657"/>
            <a:chOff x="1447799" y="457200"/>
            <a:chExt cx="381000" cy="78771"/>
          </a:xfrm>
        </p:grpSpPr>
        <p:cxnSp>
          <p:nvCxnSpPr>
            <p:cNvPr id="626" name="Gerade Verbindung 625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7" name="Gerade Verbindung 626"/>
            <p:cNvCxnSpPr/>
            <p:nvPr/>
          </p:nvCxnSpPr>
          <p:spPr>
            <a:xfrm>
              <a:off x="1827836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8" name="Gerade Verbindung 627"/>
            <p:cNvCxnSpPr/>
            <p:nvPr/>
          </p:nvCxnSpPr>
          <p:spPr>
            <a:xfrm flipH="1">
              <a:off x="1447799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9" name="Textfeld 628"/>
          <p:cNvSpPr txBox="1"/>
          <p:nvPr/>
        </p:nvSpPr>
        <p:spPr>
          <a:xfrm>
            <a:off x="5359805" y="5154092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30" name="Gruppieren 629"/>
          <p:cNvGrpSpPr/>
          <p:nvPr/>
        </p:nvGrpSpPr>
        <p:grpSpPr>
          <a:xfrm>
            <a:off x="5345007" y="5280866"/>
            <a:ext cx="348714" cy="87477"/>
            <a:chOff x="1447800" y="455142"/>
            <a:chExt cx="383732" cy="63766"/>
          </a:xfrm>
        </p:grpSpPr>
        <p:cxnSp>
          <p:nvCxnSpPr>
            <p:cNvPr id="631" name="Gerade Verbindung 630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2" name="Gerade Verbindung 631"/>
            <p:cNvCxnSpPr/>
            <p:nvPr/>
          </p:nvCxnSpPr>
          <p:spPr>
            <a:xfrm>
              <a:off x="1831532" y="455142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3" name="Gerade Verbindung 63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4" name="Gruppieren 633"/>
          <p:cNvGrpSpPr/>
          <p:nvPr/>
        </p:nvGrpSpPr>
        <p:grpSpPr>
          <a:xfrm>
            <a:off x="5345175" y="5115312"/>
            <a:ext cx="674709" cy="86293"/>
            <a:chOff x="2868920" y="5536746"/>
            <a:chExt cx="674709" cy="86293"/>
          </a:xfrm>
        </p:grpSpPr>
        <p:cxnSp>
          <p:nvCxnSpPr>
            <p:cNvPr id="635" name="Gerade Verbindung 634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6" name="Gerade Verbindung 635"/>
            <p:cNvCxnSpPr/>
            <p:nvPr/>
          </p:nvCxnSpPr>
          <p:spPr>
            <a:xfrm>
              <a:off x="3543629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7" name="Gerade Verbindung 636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38" name="Textfeld 637"/>
          <p:cNvSpPr txBox="1"/>
          <p:nvPr/>
        </p:nvSpPr>
        <p:spPr>
          <a:xfrm>
            <a:off x="5525059" y="4988766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9" name="Textfeld 638"/>
          <p:cNvSpPr txBox="1"/>
          <p:nvPr/>
        </p:nvSpPr>
        <p:spPr>
          <a:xfrm>
            <a:off x="5661439" y="4783111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40" name="Gruppieren 639"/>
          <p:cNvGrpSpPr/>
          <p:nvPr/>
        </p:nvGrpSpPr>
        <p:grpSpPr>
          <a:xfrm>
            <a:off x="5338825" y="4918366"/>
            <a:ext cx="1022350" cy="87657"/>
            <a:chOff x="1447800" y="457200"/>
            <a:chExt cx="382775" cy="78771"/>
          </a:xfrm>
        </p:grpSpPr>
        <p:cxnSp>
          <p:nvCxnSpPr>
            <p:cNvPr id="641" name="Gerade Verbindung 640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2" name="Gerade Verbindung 641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3" name="Gerade Verbindung 64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4" name="Textfeld 643"/>
          <p:cNvSpPr txBox="1"/>
          <p:nvPr/>
        </p:nvSpPr>
        <p:spPr>
          <a:xfrm>
            <a:off x="4925675" y="4554511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Stc2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5" name="Textfeld 644"/>
          <p:cNvSpPr txBox="1"/>
          <p:nvPr/>
        </p:nvSpPr>
        <p:spPr>
          <a:xfrm>
            <a:off x="7115860" y="4554511"/>
            <a:ext cx="1799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Chr8:125563887-125565053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  <a:p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6" name="Textfeld 645"/>
          <p:cNvSpPr txBox="1"/>
          <p:nvPr/>
        </p:nvSpPr>
        <p:spPr>
          <a:xfrm>
            <a:off x="7555166" y="5026371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47" name="Gruppieren 646"/>
          <p:cNvGrpSpPr/>
          <p:nvPr/>
        </p:nvGrpSpPr>
        <p:grpSpPr>
          <a:xfrm>
            <a:off x="7535143" y="5160149"/>
            <a:ext cx="348714" cy="86854"/>
            <a:chOff x="1447800" y="457200"/>
            <a:chExt cx="383732" cy="63312"/>
          </a:xfrm>
        </p:grpSpPr>
        <p:cxnSp>
          <p:nvCxnSpPr>
            <p:cNvPr id="648" name="Gerade Verbindung 647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9" name="Gerade Verbindung 648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0" name="Gerade Verbindung 64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1" name="Gruppieren 650"/>
          <p:cNvGrpSpPr/>
          <p:nvPr/>
        </p:nvGrpSpPr>
        <p:grpSpPr>
          <a:xfrm>
            <a:off x="7533456" y="5000087"/>
            <a:ext cx="669905" cy="86293"/>
            <a:chOff x="2868920" y="5536746"/>
            <a:chExt cx="669905" cy="86293"/>
          </a:xfrm>
        </p:grpSpPr>
        <p:cxnSp>
          <p:nvCxnSpPr>
            <p:cNvPr id="652" name="Gerade Verbindung 651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3" name="Gerade Verbindung 652"/>
            <p:cNvCxnSpPr/>
            <p:nvPr/>
          </p:nvCxnSpPr>
          <p:spPr>
            <a:xfrm>
              <a:off x="3538605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4" name="Gerade Verbindung 653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5" name="Textfeld 654"/>
          <p:cNvSpPr txBox="1"/>
          <p:nvPr/>
        </p:nvSpPr>
        <p:spPr>
          <a:xfrm>
            <a:off x="7713340" y="4873541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-1690" y="0"/>
            <a:ext cx="93742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dditional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data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l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4: Validation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creening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result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by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quantitative high-resolution DNA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ssessment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155"/>
          <a:stretch/>
        </p:blipFill>
        <p:spPr bwMode="auto">
          <a:xfrm>
            <a:off x="4800177" y="540715"/>
            <a:ext cx="1774967" cy="10978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155"/>
          <a:stretch/>
        </p:blipFill>
        <p:spPr bwMode="auto">
          <a:xfrm>
            <a:off x="7005713" y="540715"/>
            <a:ext cx="1774967" cy="10978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431"/>
          <a:stretch/>
        </p:blipFill>
        <p:spPr bwMode="auto">
          <a:xfrm>
            <a:off x="2590800" y="2662523"/>
            <a:ext cx="1774968" cy="1112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431"/>
          <a:stretch/>
        </p:blipFill>
        <p:spPr bwMode="auto">
          <a:xfrm>
            <a:off x="7005713" y="2662523"/>
            <a:ext cx="1774967" cy="1112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9" name="Textfeld 318"/>
          <p:cNvSpPr txBox="1"/>
          <p:nvPr/>
        </p:nvSpPr>
        <p:spPr>
          <a:xfrm>
            <a:off x="2723181" y="312115"/>
            <a:ext cx="5006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Hic1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155"/>
          <a:stretch/>
        </p:blipFill>
        <p:spPr bwMode="auto">
          <a:xfrm>
            <a:off x="2590800" y="540715"/>
            <a:ext cx="1774968" cy="10978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9" name="Textfeld 468"/>
          <p:cNvSpPr txBox="1"/>
          <p:nvPr/>
        </p:nvSpPr>
        <p:spPr>
          <a:xfrm>
            <a:off x="944298" y="3112169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70" name="Gruppieren 469"/>
          <p:cNvGrpSpPr/>
          <p:nvPr/>
        </p:nvGrpSpPr>
        <p:grpSpPr>
          <a:xfrm>
            <a:off x="921715" y="3234583"/>
            <a:ext cx="348714" cy="88181"/>
            <a:chOff x="1447800" y="457200"/>
            <a:chExt cx="383732" cy="64279"/>
          </a:xfrm>
        </p:grpSpPr>
        <p:cxnSp>
          <p:nvCxnSpPr>
            <p:cNvPr id="471" name="Gerade Verbindung 470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2" name="Gerade Verbindung 471"/>
            <p:cNvCxnSpPr/>
            <p:nvPr/>
          </p:nvCxnSpPr>
          <p:spPr>
            <a:xfrm>
              <a:off x="1831532" y="459771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3" name="Gerade Verbindung 47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4" name="Gruppieren 473"/>
          <p:cNvGrpSpPr/>
          <p:nvPr/>
        </p:nvGrpSpPr>
        <p:grpSpPr>
          <a:xfrm>
            <a:off x="925790" y="3083655"/>
            <a:ext cx="674709" cy="86293"/>
            <a:chOff x="1447800" y="457200"/>
            <a:chExt cx="383732" cy="55500"/>
          </a:xfrm>
        </p:grpSpPr>
        <p:cxnSp>
          <p:nvCxnSpPr>
            <p:cNvPr id="475" name="Gerade Verbindung 474"/>
            <p:cNvCxnSpPr/>
            <p:nvPr/>
          </p:nvCxnSpPr>
          <p:spPr>
            <a:xfrm>
              <a:off x="1447800" y="457200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6" name="Gerade Verbindung 475"/>
            <p:cNvCxnSpPr/>
            <p:nvPr/>
          </p:nvCxnSpPr>
          <p:spPr>
            <a:xfrm>
              <a:off x="1831532" y="459771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7" name="Gerade Verbindung 47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8" name="Textfeld 477"/>
          <p:cNvSpPr txBox="1"/>
          <p:nvPr/>
        </p:nvSpPr>
        <p:spPr>
          <a:xfrm>
            <a:off x="1095002" y="2944700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9" name="Textfeld 478"/>
          <p:cNvSpPr txBox="1"/>
          <p:nvPr/>
        </p:nvSpPr>
        <p:spPr>
          <a:xfrm>
            <a:off x="1234342" y="2771781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80" name="Gruppieren 479"/>
          <p:cNvGrpSpPr/>
          <p:nvPr/>
        </p:nvGrpSpPr>
        <p:grpSpPr>
          <a:xfrm>
            <a:off x="922659" y="2901741"/>
            <a:ext cx="1022350" cy="87657"/>
            <a:chOff x="1447800" y="457200"/>
            <a:chExt cx="382775" cy="78771"/>
          </a:xfrm>
        </p:grpSpPr>
        <p:cxnSp>
          <p:nvCxnSpPr>
            <p:cNvPr id="481" name="Gerade Verbindung 480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2" name="Gerade Verbindung 481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3" name="Gerade Verbindung 48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4" name="Textfeld 483"/>
          <p:cNvSpPr txBox="1"/>
          <p:nvPr/>
        </p:nvSpPr>
        <p:spPr>
          <a:xfrm>
            <a:off x="501090" y="2433313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Egr3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5" name="Gruppieren 194"/>
          <p:cNvGrpSpPr/>
          <p:nvPr/>
        </p:nvGrpSpPr>
        <p:grpSpPr>
          <a:xfrm>
            <a:off x="916650" y="778673"/>
            <a:ext cx="1017609" cy="87657"/>
            <a:chOff x="1447800" y="457200"/>
            <a:chExt cx="381000" cy="78771"/>
          </a:xfrm>
        </p:grpSpPr>
        <p:cxnSp>
          <p:nvCxnSpPr>
            <p:cNvPr id="220" name="Gerade Verbindung 219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Gerade Verbindung 220"/>
            <p:cNvCxnSpPr/>
            <p:nvPr/>
          </p:nvCxnSpPr>
          <p:spPr>
            <a:xfrm>
              <a:off x="1828596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Gerade Verbindung 222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4" name="Textfeld 223"/>
          <p:cNvSpPr txBox="1"/>
          <p:nvPr/>
        </p:nvSpPr>
        <p:spPr>
          <a:xfrm>
            <a:off x="1246851" y="645323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5" name="Gruppieren 224"/>
          <p:cNvGrpSpPr/>
          <p:nvPr/>
        </p:nvGrpSpPr>
        <p:grpSpPr>
          <a:xfrm>
            <a:off x="1259551" y="618274"/>
            <a:ext cx="674709" cy="86294"/>
            <a:chOff x="1447800" y="549102"/>
            <a:chExt cx="383732" cy="55502"/>
          </a:xfrm>
        </p:grpSpPr>
        <p:cxnSp>
          <p:nvCxnSpPr>
            <p:cNvPr id="226" name="Gerade Verbindung 225"/>
            <p:cNvCxnSpPr/>
            <p:nvPr/>
          </p:nvCxnSpPr>
          <p:spPr>
            <a:xfrm>
              <a:off x="1447800" y="549102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Gerade Verbindung 226"/>
            <p:cNvCxnSpPr/>
            <p:nvPr/>
          </p:nvCxnSpPr>
          <p:spPr>
            <a:xfrm>
              <a:off x="1831532" y="551675"/>
              <a:ext cx="0" cy="5292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Gerade Verbindung 227"/>
            <p:cNvCxnSpPr/>
            <p:nvPr/>
          </p:nvCxnSpPr>
          <p:spPr>
            <a:xfrm flipH="1">
              <a:off x="1447800" y="549102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9" name="Textfeld 228"/>
          <p:cNvSpPr txBox="1"/>
          <p:nvPr/>
        </p:nvSpPr>
        <p:spPr>
          <a:xfrm>
            <a:off x="1500851" y="491746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0" name="Gruppieren 229"/>
          <p:cNvGrpSpPr/>
          <p:nvPr/>
        </p:nvGrpSpPr>
        <p:grpSpPr>
          <a:xfrm>
            <a:off x="1585546" y="454237"/>
            <a:ext cx="348714" cy="88178"/>
            <a:chOff x="1447800" y="608424"/>
            <a:chExt cx="383732" cy="64278"/>
          </a:xfrm>
        </p:grpSpPr>
        <p:cxnSp>
          <p:nvCxnSpPr>
            <p:cNvPr id="231" name="Gerade Verbindung 230"/>
            <p:cNvCxnSpPr/>
            <p:nvPr/>
          </p:nvCxnSpPr>
          <p:spPr>
            <a:xfrm>
              <a:off x="1447800" y="60842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Gerade Verbindung 231"/>
            <p:cNvCxnSpPr/>
            <p:nvPr/>
          </p:nvCxnSpPr>
          <p:spPr>
            <a:xfrm>
              <a:off x="1831532" y="61099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Gerade Verbindung 232"/>
            <p:cNvCxnSpPr/>
            <p:nvPr/>
          </p:nvCxnSpPr>
          <p:spPr>
            <a:xfrm flipH="1">
              <a:off x="1447800" y="608424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4" name="Textfeld 233"/>
          <p:cNvSpPr txBox="1"/>
          <p:nvPr/>
        </p:nvSpPr>
        <p:spPr>
          <a:xfrm>
            <a:off x="1656185" y="334060"/>
            <a:ext cx="1812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Textfeld 234"/>
          <p:cNvSpPr txBox="1"/>
          <p:nvPr/>
        </p:nvSpPr>
        <p:spPr>
          <a:xfrm>
            <a:off x="501090" y="312115"/>
            <a:ext cx="5006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Il4i1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2" name="Textfeld 581"/>
          <p:cNvSpPr txBox="1"/>
          <p:nvPr/>
        </p:nvSpPr>
        <p:spPr>
          <a:xfrm>
            <a:off x="501090" y="4554511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Zfp775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8" name="Textfeld 597"/>
          <p:cNvSpPr txBox="1"/>
          <p:nvPr/>
        </p:nvSpPr>
        <p:spPr>
          <a:xfrm>
            <a:off x="962746" y="5292076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0" name="Gerade Verbindung 599"/>
          <p:cNvCxnSpPr/>
          <p:nvPr/>
        </p:nvCxnSpPr>
        <p:spPr>
          <a:xfrm>
            <a:off x="907932" y="5413805"/>
            <a:ext cx="0" cy="8465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1" name="Gerade Verbindung 600"/>
          <p:cNvCxnSpPr/>
          <p:nvPr/>
        </p:nvCxnSpPr>
        <p:spPr>
          <a:xfrm>
            <a:off x="1256646" y="5417332"/>
            <a:ext cx="0" cy="8465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2" name="Gerade Verbindung 601"/>
          <p:cNvCxnSpPr/>
          <p:nvPr/>
        </p:nvCxnSpPr>
        <p:spPr>
          <a:xfrm flipH="1">
            <a:off x="907932" y="5413805"/>
            <a:ext cx="34623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4" name="Gerade Verbindung 603"/>
          <p:cNvCxnSpPr/>
          <p:nvPr/>
        </p:nvCxnSpPr>
        <p:spPr>
          <a:xfrm>
            <a:off x="908843" y="5226421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5" name="Gerade Verbindung 604"/>
          <p:cNvCxnSpPr/>
          <p:nvPr/>
        </p:nvCxnSpPr>
        <p:spPr>
          <a:xfrm>
            <a:off x="1583552" y="5230418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6" name="Gerade Verbindung 605"/>
          <p:cNvCxnSpPr/>
          <p:nvPr/>
        </p:nvCxnSpPr>
        <p:spPr>
          <a:xfrm flipH="1">
            <a:off x="908843" y="5226421"/>
            <a:ext cx="66990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7" name="Textfeld 606"/>
          <p:cNvSpPr txBox="1"/>
          <p:nvPr/>
        </p:nvSpPr>
        <p:spPr>
          <a:xfrm>
            <a:off x="1135332" y="5097716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8" name="Textfeld 607"/>
          <p:cNvSpPr txBox="1"/>
          <p:nvPr/>
        </p:nvSpPr>
        <p:spPr>
          <a:xfrm>
            <a:off x="1288713" y="4920881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10" name="Gerade Verbindung 609"/>
          <p:cNvCxnSpPr/>
          <p:nvPr/>
        </p:nvCxnSpPr>
        <p:spPr>
          <a:xfrm>
            <a:off x="916802" y="5050980"/>
            <a:ext cx="0" cy="847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1" name="Gerade Verbindung 610"/>
          <p:cNvCxnSpPr/>
          <p:nvPr/>
        </p:nvCxnSpPr>
        <p:spPr>
          <a:xfrm>
            <a:off x="1939152" y="5053841"/>
            <a:ext cx="0" cy="847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2" name="Gerade Verbindung 611"/>
          <p:cNvCxnSpPr/>
          <p:nvPr/>
        </p:nvCxnSpPr>
        <p:spPr>
          <a:xfrm flipH="1">
            <a:off x="916802" y="5050980"/>
            <a:ext cx="1017609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155"/>
          <a:stretch/>
        </p:blipFill>
        <p:spPr bwMode="auto">
          <a:xfrm>
            <a:off x="385138" y="540715"/>
            <a:ext cx="1774968" cy="10978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431"/>
          <a:stretch/>
        </p:blipFill>
        <p:spPr bwMode="auto">
          <a:xfrm>
            <a:off x="385138" y="2662523"/>
            <a:ext cx="1774968" cy="1112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537"/>
          <a:stretch/>
        </p:blipFill>
        <p:spPr bwMode="auto">
          <a:xfrm>
            <a:off x="385138" y="4791036"/>
            <a:ext cx="1774968" cy="10903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3" name="Picture 11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436"/>
          <a:stretch/>
        </p:blipFill>
        <p:spPr bwMode="auto">
          <a:xfrm>
            <a:off x="2590800" y="4791036"/>
            <a:ext cx="1774968" cy="11120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4" name="Picture 12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436"/>
          <a:stretch/>
        </p:blipFill>
        <p:spPr bwMode="auto">
          <a:xfrm>
            <a:off x="4800177" y="4791036"/>
            <a:ext cx="1774968" cy="11120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436"/>
          <a:stretch/>
        </p:blipFill>
        <p:spPr bwMode="auto">
          <a:xfrm>
            <a:off x="7005713" y="4791036"/>
            <a:ext cx="1774967" cy="11120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" name="Gruppieren 6"/>
          <p:cNvGrpSpPr/>
          <p:nvPr/>
        </p:nvGrpSpPr>
        <p:grpSpPr>
          <a:xfrm>
            <a:off x="250545" y="1419259"/>
            <a:ext cx="1507847" cy="1005403"/>
            <a:chOff x="256727" y="1419259"/>
            <a:chExt cx="1507847" cy="1005403"/>
          </a:xfrm>
        </p:grpSpPr>
        <p:sp>
          <p:nvSpPr>
            <p:cNvPr id="5" name="Textfeld 4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6" name="Rechteck 5"/>
            <p:cNvSpPr/>
            <p:nvPr/>
          </p:nvSpPr>
          <p:spPr>
            <a:xfrm rot="18885091">
              <a:off x="542511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36" name="Rechteck 235"/>
            <p:cNvSpPr/>
            <p:nvPr/>
          </p:nvSpPr>
          <p:spPr>
            <a:xfrm rot="18885091">
              <a:off x="794680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7" name="Rechteck 236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8" name="Gruppieren 237"/>
          <p:cNvGrpSpPr/>
          <p:nvPr/>
        </p:nvGrpSpPr>
        <p:grpSpPr>
          <a:xfrm>
            <a:off x="2453030" y="1419259"/>
            <a:ext cx="1507847" cy="1005403"/>
            <a:chOff x="256727" y="1419259"/>
            <a:chExt cx="1507847" cy="1005403"/>
          </a:xfrm>
        </p:grpSpPr>
        <p:sp>
          <p:nvSpPr>
            <p:cNvPr id="239" name="Textfeld 23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40" name="Rechteck 239"/>
            <p:cNvSpPr/>
            <p:nvPr/>
          </p:nvSpPr>
          <p:spPr>
            <a:xfrm rot="18885091">
              <a:off x="549826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41" name="Rechteck 240"/>
            <p:cNvSpPr/>
            <p:nvPr/>
          </p:nvSpPr>
          <p:spPr>
            <a:xfrm rot="18885091">
              <a:off x="801995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Rechteck 241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6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3" name="Gruppieren 242"/>
          <p:cNvGrpSpPr/>
          <p:nvPr/>
        </p:nvGrpSpPr>
        <p:grpSpPr>
          <a:xfrm>
            <a:off x="4671668" y="1414854"/>
            <a:ext cx="1507847" cy="1005403"/>
            <a:chOff x="256727" y="1419259"/>
            <a:chExt cx="1507847" cy="1005403"/>
          </a:xfrm>
        </p:grpSpPr>
        <p:sp>
          <p:nvSpPr>
            <p:cNvPr id="244" name="Textfeld 243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45" name="Rechteck 244"/>
            <p:cNvSpPr/>
            <p:nvPr/>
          </p:nvSpPr>
          <p:spPr>
            <a:xfrm rot="18885091">
              <a:off x="548939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46" name="Rechteck 245"/>
            <p:cNvSpPr/>
            <p:nvPr/>
          </p:nvSpPr>
          <p:spPr>
            <a:xfrm rot="18885091">
              <a:off x="797798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Rechteck 246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8" name="Gruppieren 247"/>
          <p:cNvGrpSpPr/>
          <p:nvPr/>
        </p:nvGrpSpPr>
        <p:grpSpPr>
          <a:xfrm>
            <a:off x="6874153" y="1417731"/>
            <a:ext cx="1505827" cy="1005403"/>
            <a:chOff x="256727" y="1419259"/>
            <a:chExt cx="1505827" cy="1005403"/>
          </a:xfrm>
        </p:grpSpPr>
        <p:sp>
          <p:nvSpPr>
            <p:cNvPr id="249" name="Textfeld 24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50" name="Rechteck 249"/>
            <p:cNvSpPr/>
            <p:nvPr/>
          </p:nvSpPr>
          <p:spPr>
            <a:xfrm rot="18885091">
              <a:off x="548303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51" name="Rechteck 250"/>
            <p:cNvSpPr/>
            <p:nvPr/>
          </p:nvSpPr>
          <p:spPr>
            <a:xfrm rot="18885091">
              <a:off x="795831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2" name="Rechteck 251"/>
            <p:cNvSpPr/>
            <p:nvPr/>
          </p:nvSpPr>
          <p:spPr>
            <a:xfrm rot="18885091">
              <a:off x="1174252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53" name="Gruppieren 252"/>
          <p:cNvGrpSpPr/>
          <p:nvPr/>
        </p:nvGrpSpPr>
        <p:grpSpPr>
          <a:xfrm>
            <a:off x="6874153" y="3536065"/>
            <a:ext cx="1507847" cy="1005403"/>
            <a:chOff x="256727" y="1411308"/>
            <a:chExt cx="1507847" cy="1005403"/>
          </a:xfrm>
        </p:grpSpPr>
        <p:sp>
          <p:nvSpPr>
            <p:cNvPr id="254" name="Textfeld 253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55" name="Rechteck 254"/>
            <p:cNvSpPr/>
            <p:nvPr/>
          </p:nvSpPr>
          <p:spPr>
            <a:xfrm rot="18885091">
              <a:off x="5403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56" name="Rechteck 255"/>
            <p:cNvSpPr/>
            <p:nvPr/>
          </p:nvSpPr>
          <p:spPr>
            <a:xfrm rot="18885091">
              <a:off x="792521" y="1813982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7" name="Rechteck 256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58" name="Gruppieren 257"/>
          <p:cNvGrpSpPr/>
          <p:nvPr/>
        </p:nvGrpSpPr>
        <p:grpSpPr>
          <a:xfrm>
            <a:off x="4671668" y="3536065"/>
            <a:ext cx="1507847" cy="1005403"/>
            <a:chOff x="256727" y="1411308"/>
            <a:chExt cx="1507847" cy="1005403"/>
          </a:xfrm>
        </p:grpSpPr>
        <p:sp>
          <p:nvSpPr>
            <p:cNvPr id="259" name="Textfeld 25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60" name="Rechteck 259"/>
            <p:cNvSpPr/>
            <p:nvPr/>
          </p:nvSpPr>
          <p:spPr>
            <a:xfrm rot="18885091">
              <a:off x="548939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61" name="Rechteck 260"/>
            <p:cNvSpPr/>
            <p:nvPr/>
          </p:nvSpPr>
          <p:spPr>
            <a:xfrm rot="18885091">
              <a:off x="793157" y="1813982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Rechteck 261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6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3" name="Gruppieren 262"/>
          <p:cNvGrpSpPr/>
          <p:nvPr/>
        </p:nvGrpSpPr>
        <p:grpSpPr>
          <a:xfrm>
            <a:off x="2453030" y="3533188"/>
            <a:ext cx="1507847" cy="1005403"/>
            <a:chOff x="256727" y="1411308"/>
            <a:chExt cx="1507847" cy="1005403"/>
          </a:xfrm>
        </p:grpSpPr>
        <p:sp>
          <p:nvSpPr>
            <p:cNvPr id="264" name="Textfeld 263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65" name="Rechteck 264"/>
            <p:cNvSpPr/>
            <p:nvPr/>
          </p:nvSpPr>
          <p:spPr>
            <a:xfrm rot="18885091">
              <a:off x="549826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66" name="Rechteck 265"/>
            <p:cNvSpPr/>
            <p:nvPr/>
          </p:nvSpPr>
          <p:spPr>
            <a:xfrm rot="18885091">
              <a:off x="814587" y="1813982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7" name="Rechteck 266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8" name="Gruppieren 267"/>
          <p:cNvGrpSpPr/>
          <p:nvPr/>
        </p:nvGrpSpPr>
        <p:grpSpPr>
          <a:xfrm>
            <a:off x="250545" y="3533188"/>
            <a:ext cx="1507847" cy="1005403"/>
            <a:chOff x="256727" y="1411308"/>
            <a:chExt cx="1507847" cy="1005403"/>
          </a:xfrm>
        </p:grpSpPr>
        <p:sp>
          <p:nvSpPr>
            <p:cNvPr id="269" name="Textfeld 26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70" name="Rechteck 269"/>
            <p:cNvSpPr/>
            <p:nvPr/>
          </p:nvSpPr>
          <p:spPr>
            <a:xfrm rot="18885091">
              <a:off x="542511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71" name="Rechteck 270"/>
            <p:cNvSpPr/>
            <p:nvPr/>
          </p:nvSpPr>
          <p:spPr>
            <a:xfrm rot="18885091">
              <a:off x="810582" y="1813982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Rechteck 271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73" name="Gruppieren 272"/>
          <p:cNvGrpSpPr/>
          <p:nvPr/>
        </p:nvGrpSpPr>
        <p:grpSpPr>
          <a:xfrm>
            <a:off x="250545" y="5659473"/>
            <a:ext cx="1507847" cy="1005403"/>
            <a:chOff x="256727" y="1411308"/>
            <a:chExt cx="1507847" cy="1005403"/>
          </a:xfrm>
        </p:grpSpPr>
        <p:sp>
          <p:nvSpPr>
            <p:cNvPr id="274" name="Textfeld 273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75" name="Rechteck 274"/>
            <p:cNvSpPr/>
            <p:nvPr/>
          </p:nvSpPr>
          <p:spPr>
            <a:xfrm rot="18885091">
              <a:off x="542511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76" name="Rechteck 275"/>
            <p:cNvSpPr/>
            <p:nvPr/>
          </p:nvSpPr>
          <p:spPr>
            <a:xfrm rot="18885091">
              <a:off x="807272" y="1813982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7" name="Rechteck 276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78" name="Gruppieren 277"/>
          <p:cNvGrpSpPr/>
          <p:nvPr/>
        </p:nvGrpSpPr>
        <p:grpSpPr>
          <a:xfrm>
            <a:off x="2453030" y="5659473"/>
            <a:ext cx="1507847" cy="1005403"/>
            <a:chOff x="256727" y="1411308"/>
            <a:chExt cx="1507847" cy="1005403"/>
          </a:xfrm>
        </p:grpSpPr>
        <p:sp>
          <p:nvSpPr>
            <p:cNvPr id="279" name="Textfeld 27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80" name="Rechteck 279"/>
            <p:cNvSpPr/>
            <p:nvPr/>
          </p:nvSpPr>
          <p:spPr>
            <a:xfrm rot="18885091">
              <a:off x="549826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81" name="Rechteck 280"/>
            <p:cNvSpPr/>
            <p:nvPr/>
          </p:nvSpPr>
          <p:spPr>
            <a:xfrm rot="18885091">
              <a:off x="801995" y="1813982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Rechteck 281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3" name="Gruppieren 282"/>
          <p:cNvGrpSpPr/>
          <p:nvPr/>
        </p:nvGrpSpPr>
        <p:grpSpPr>
          <a:xfrm>
            <a:off x="4671668" y="5659473"/>
            <a:ext cx="1507847" cy="1005403"/>
            <a:chOff x="256727" y="1411308"/>
            <a:chExt cx="1507847" cy="1005403"/>
          </a:xfrm>
        </p:grpSpPr>
        <p:sp>
          <p:nvSpPr>
            <p:cNvPr id="284" name="Textfeld 283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85" name="Rechteck 284"/>
            <p:cNvSpPr/>
            <p:nvPr/>
          </p:nvSpPr>
          <p:spPr>
            <a:xfrm rot="18885091">
              <a:off x="548939" y="1778259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86" name="Rechteck 285"/>
            <p:cNvSpPr/>
            <p:nvPr/>
          </p:nvSpPr>
          <p:spPr>
            <a:xfrm rot="18885091">
              <a:off x="797798" y="1813982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" name="Rechteck 286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8" name="Gruppieren 287"/>
          <p:cNvGrpSpPr/>
          <p:nvPr/>
        </p:nvGrpSpPr>
        <p:grpSpPr>
          <a:xfrm>
            <a:off x="6874153" y="5667424"/>
            <a:ext cx="1507847" cy="1005403"/>
            <a:chOff x="256727" y="1419259"/>
            <a:chExt cx="1507847" cy="1005403"/>
          </a:xfrm>
        </p:grpSpPr>
        <p:sp>
          <p:nvSpPr>
            <p:cNvPr id="289" name="Textfeld 28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90" name="Rechteck 289"/>
            <p:cNvSpPr/>
            <p:nvPr/>
          </p:nvSpPr>
          <p:spPr>
            <a:xfrm rot="18885091">
              <a:off x="543008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91" name="Rechteck 290"/>
            <p:cNvSpPr/>
            <p:nvPr/>
          </p:nvSpPr>
          <p:spPr>
            <a:xfrm rot="18885091">
              <a:off x="808423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Rechteck 291"/>
            <p:cNvSpPr/>
            <p:nvPr/>
          </p:nvSpPr>
          <p:spPr>
            <a:xfrm rot="18885091">
              <a:off x="1176272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66443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814"/>
          <a:stretch/>
        </p:blipFill>
        <p:spPr bwMode="auto">
          <a:xfrm>
            <a:off x="2586112" y="541325"/>
            <a:ext cx="1774967" cy="11045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814"/>
          <a:stretch/>
        </p:blipFill>
        <p:spPr bwMode="auto">
          <a:xfrm>
            <a:off x="381000" y="541325"/>
            <a:ext cx="1774967" cy="11045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4" name="Textfeld 433"/>
          <p:cNvSpPr txBox="1"/>
          <p:nvPr/>
        </p:nvSpPr>
        <p:spPr>
          <a:xfrm>
            <a:off x="3144663" y="942502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35" name="Gruppieren 434"/>
          <p:cNvGrpSpPr/>
          <p:nvPr/>
        </p:nvGrpSpPr>
        <p:grpSpPr>
          <a:xfrm>
            <a:off x="3127108" y="1065598"/>
            <a:ext cx="348714" cy="86854"/>
            <a:chOff x="1447800" y="457200"/>
            <a:chExt cx="383732" cy="63312"/>
          </a:xfrm>
        </p:grpSpPr>
        <p:cxnSp>
          <p:nvCxnSpPr>
            <p:cNvPr id="436" name="Gerade Verbindung 435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7" name="Gerade Verbindung 436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8" name="Gerade Verbindung 437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9" name="Gruppieren 438"/>
          <p:cNvGrpSpPr/>
          <p:nvPr/>
        </p:nvGrpSpPr>
        <p:grpSpPr>
          <a:xfrm>
            <a:off x="3126629" y="907440"/>
            <a:ext cx="669905" cy="86293"/>
            <a:chOff x="2868920" y="5536746"/>
            <a:chExt cx="669905" cy="86293"/>
          </a:xfrm>
        </p:grpSpPr>
        <p:cxnSp>
          <p:nvCxnSpPr>
            <p:cNvPr id="440" name="Gerade Verbindung 439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1" name="Gerade Verbindung 440"/>
            <p:cNvCxnSpPr/>
            <p:nvPr/>
          </p:nvCxnSpPr>
          <p:spPr>
            <a:xfrm>
              <a:off x="3538605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2" name="Gerade Verbindung 441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3" name="Textfeld 442"/>
          <p:cNvSpPr txBox="1"/>
          <p:nvPr/>
        </p:nvSpPr>
        <p:spPr>
          <a:xfrm>
            <a:off x="3336657" y="780894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4" name="Textfeld 443"/>
          <p:cNvSpPr txBox="1"/>
          <p:nvPr/>
        </p:nvSpPr>
        <p:spPr>
          <a:xfrm>
            <a:off x="3473522" y="580340"/>
            <a:ext cx="3148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45" name="Gruppieren 444"/>
          <p:cNvGrpSpPr/>
          <p:nvPr/>
        </p:nvGrpSpPr>
        <p:grpSpPr>
          <a:xfrm>
            <a:off x="3124200" y="700523"/>
            <a:ext cx="1022350" cy="87657"/>
            <a:chOff x="1447800" y="457200"/>
            <a:chExt cx="382775" cy="78771"/>
          </a:xfrm>
        </p:grpSpPr>
        <p:cxnSp>
          <p:nvCxnSpPr>
            <p:cNvPr id="446" name="Gerade Verbindung 445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7" name="Gerade Verbindung 446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8" name="Gerade Verbindung 447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9" name="Textfeld 448"/>
          <p:cNvSpPr txBox="1"/>
          <p:nvPr/>
        </p:nvSpPr>
        <p:spPr>
          <a:xfrm>
            <a:off x="2688945" y="312725"/>
            <a:ext cx="651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12000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0" name="Textfeld 449"/>
          <p:cNvSpPr txBox="1"/>
          <p:nvPr/>
        </p:nvSpPr>
        <p:spPr>
          <a:xfrm>
            <a:off x="4912428" y="312725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Mab21l1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6" name="Textfeld 455"/>
          <p:cNvSpPr txBox="1"/>
          <p:nvPr/>
        </p:nvSpPr>
        <p:spPr>
          <a:xfrm>
            <a:off x="5674484" y="624272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8" name="Gerade Verbindung 457"/>
          <p:cNvCxnSpPr/>
          <p:nvPr/>
        </p:nvCxnSpPr>
        <p:spPr>
          <a:xfrm>
            <a:off x="5328922" y="744455"/>
            <a:ext cx="0" cy="847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9" name="Gerade Verbindung 458"/>
          <p:cNvCxnSpPr/>
          <p:nvPr/>
        </p:nvCxnSpPr>
        <p:spPr>
          <a:xfrm>
            <a:off x="6354290" y="747316"/>
            <a:ext cx="0" cy="847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0" name="Gerade Verbindung 459"/>
          <p:cNvCxnSpPr/>
          <p:nvPr/>
        </p:nvCxnSpPr>
        <p:spPr>
          <a:xfrm flipH="1">
            <a:off x="5328922" y="744455"/>
            <a:ext cx="1017609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2" name="Gerade Verbindung 461"/>
          <p:cNvCxnSpPr/>
          <p:nvPr/>
        </p:nvCxnSpPr>
        <p:spPr>
          <a:xfrm>
            <a:off x="5658193" y="548578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3" name="Gerade Verbindung 462"/>
          <p:cNvCxnSpPr/>
          <p:nvPr/>
        </p:nvCxnSpPr>
        <p:spPr>
          <a:xfrm>
            <a:off x="6332641" y="552575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4" name="Gerade Verbindung 463"/>
          <p:cNvCxnSpPr/>
          <p:nvPr/>
        </p:nvCxnSpPr>
        <p:spPr>
          <a:xfrm flipH="1">
            <a:off x="5658193" y="548578"/>
            <a:ext cx="66990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5" name="Textfeld 464"/>
          <p:cNvSpPr txBox="1"/>
          <p:nvPr/>
        </p:nvSpPr>
        <p:spPr>
          <a:xfrm>
            <a:off x="5904759" y="422032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67" name="Gerade Verbindung 466"/>
          <p:cNvCxnSpPr/>
          <p:nvPr/>
        </p:nvCxnSpPr>
        <p:spPr>
          <a:xfrm>
            <a:off x="5329384" y="957431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8" name="Gerade Verbindung 467"/>
          <p:cNvCxnSpPr/>
          <p:nvPr/>
        </p:nvCxnSpPr>
        <p:spPr>
          <a:xfrm>
            <a:off x="6003832" y="961428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9" name="Gerade Verbindung 468"/>
          <p:cNvCxnSpPr/>
          <p:nvPr/>
        </p:nvCxnSpPr>
        <p:spPr>
          <a:xfrm flipH="1">
            <a:off x="5329384" y="957431"/>
            <a:ext cx="66990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0" name="Textfeld 469"/>
          <p:cNvSpPr txBox="1"/>
          <p:nvPr/>
        </p:nvSpPr>
        <p:spPr>
          <a:xfrm>
            <a:off x="5554005" y="83088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1" name="Textfeld 470"/>
          <p:cNvSpPr txBox="1"/>
          <p:nvPr/>
        </p:nvSpPr>
        <p:spPr>
          <a:xfrm>
            <a:off x="7116290" y="269595"/>
            <a:ext cx="115141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Chr6:030888000-030889519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  <a:p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73" name="Gerade Verbindung 472"/>
          <p:cNvCxnSpPr/>
          <p:nvPr/>
        </p:nvCxnSpPr>
        <p:spPr>
          <a:xfrm>
            <a:off x="7535910" y="1045489"/>
            <a:ext cx="0" cy="8465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4" name="Gerade Verbindung 473"/>
          <p:cNvCxnSpPr/>
          <p:nvPr/>
        </p:nvCxnSpPr>
        <p:spPr>
          <a:xfrm>
            <a:off x="7884624" y="1047689"/>
            <a:ext cx="0" cy="8465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5" name="Gerade Verbindung 474"/>
          <p:cNvCxnSpPr/>
          <p:nvPr/>
        </p:nvCxnSpPr>
        <p:spPr>
          <a:xfrm flipH="1">
            <a:off x="7535910" y="1045489"/>
            <a:ext cx="34623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6" name="Textfeld 475"/>
          <p:cNvSpPr txBox="1"/>
          <p:nvPr/>
        </p:nvSpPr>
        <p:spPr>
          <a:xfrm>
            <a:off x="7560851" y="912288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7" name="Textfeld 476"/>
          <p:cNvSpPr txBox="1"/>
          <p:nvPr/>
        </p:nvSpPr>
        <p:spPr>
          <a:xfrm>
            <a:off x="7884171" y="639427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79" name="Gerade Verbindung 478"/>
          <p:cNvCxnSpPr/>
          <p:nvPr/>
        </p:nvCxnSpPr>
        <p:spPr>
          <a:xfrm>
            <a:off x="7538609" y="759610"/>
            <a:ext cx="0" cy="847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0" name="Gerade Verbindung 479"/>
          <p:cNvCxnSpPr/>
          <p:nvPr/>
        </p:nvCxnSpPr>
        <p:spPr>
          <a:xfrm>
            <a:off x="8555350" y="762471"/>
            <a:ext cx="0" cy="847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1" name="Gerade Verbindung 480"/>
          <p:cNvCxnSpPr/>
          <p:nvPr/>
        </p:nvCxnSpPr>
        <p:spPr>
          <a:xfrm flipH="1">
            <a:off x="7538609" y="759610"/>
            <a:ext cx="1017609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Gerade Verbindung 482"/>
          <p:cNvCxnSpPr/>
          <p:nvPr/>
        </p:nvCxnSpPr>
        <p:spPr>
          <a:xfrm>
            <a:off x="7538874" y="912477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4" name="Gerade Verbindung 483"/>
          <p:cNvCxnSpPr/>
          <p:nvPr/>
        </p:nvCxnSpPr>
        <p:spPr>
          <a:xfrm>
            <a:off x="8208298" y="916474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5" name="Gerade Verbindung 484"/>
          <p:cNvCxnSpPr/>
          <p:nvPr/>
        </p:nvCxnSpPr>
        <p:spPr>
          <a:xfrm flipH="1">
            <a:off x="7538874" y="912477"/>
            <a:ext cx="66990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6" name="Textfeld 485"/>
          <p:cNvSpPr txBox="1"/>
          <p:nvPr/>
        </p:nvSpPr>
        <p:spPr>
          <a:xfrm>
            <a:off x="7748865" y="785931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88" name="Gerade Verbindung 487"/>
          <p:cNvCxnSpPr/>
          <p:nvPr/>
        </p:nvCxnSpPr>
        <p:spPr>
          <a:xfrm>
            <a:off x="7886533" y="618328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9" name="Gerade Verbindung 488"/>
          <p:cNvCxnSpPr/>
          <p:nvPr/>
        </p:nvCxnSpPr>
        <p:spPr>
          <a:xfrm>
            <a:off x="8560981" y="622325"/>
            <a:ext cx="0" cy="8229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0" name="Gerade Verbindung 489"/>
          <p:cNvCxnSpPr/>
          <p:nvPr/>
        </p:nvCxnSpPr>
        <p:spPr>
          <a:xfrm flipH="1">
            <a:off x="7886533" y="618328"/>
            <a:ext cx="66990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1" name="Textfeld 490"/>
          <p:cNvSpPr txBox="1"/>
          <p:nvPr/>
        </p:nvSpPr>
        <p:spPr>
          <a:xfrm>
            <a:off x="8103839" y="491782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93" name="Gerade Verbindung 492"/>
          <p:cNvCxnSpPr/>
          <p:nvPr/>
        </p:nvCxnSpPr>
        <p:spPr>
          <a:xfrm>
            <a:off x="8207429" y="444005"/>
            <a:ext cx="0" cy="8465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4" name="Gerade Verbindung 493"/>
          <p:cNvCxnSpPr/>
          <p:nvPr/>
        </p:nvCxnSpPr>
        <p:spPr>
          <a:xfrm>
            <a:off x="8556143" y="446205"/>
            <a:ext cx="0" cy="8465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Gerade Verbindung 494"/>
          <p:cNvCxnSpPr/>
          <p:nvPr/>
        </p:nvCxnSpPr>
        <p:spPr>
          <a:xfrm flipH="1">
            <a:off x="8207429" y="444005"/>
            <a:ext cx="346231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6" name="Textfeld 495"/>
          <p:cNvSpPr txBox="1"/>
          <p:nvPr/>
        </p:nvSpPr>
        <p:spPr>
          <a:xfrm>
            <a:off x="8267700" y="319430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9" name="Textfeld 298"/>
          <p:cNvSpPr txBox="1"/>
          <p:nvPr/>
        </p:nvSpPr>
        <p:spPr>
          <a:xfrm>
            <a:off x="493774" y="312725"/>
            <a:ext cx="18684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Chr5:067705737-067707409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  <a:p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0" name="Textfeld 299"/>
          <p:cNvSpPr txBox="1"/>
          <p:nvPr/>
        </p:nvSpPr>
        <p:spPr>
          <a:xfrm>
            <a:off x="927460" y="847629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1" name="Gruppieren 300"/>
          <p:cNvGrpSpPr/>
          <p:nvPr/>
        </p:nvGrpSpPr>
        <p:grpSpPr>
          <a:xfrm>
            <a:off x="909905" y="969885"/>
            <a:ext cx="348714" cy="86854"/>
            <a:chOff x="1447800" y="457200"/>
            <a:chExt cx="383732" cy="63312"/>
          </a:xfrm>
        </p:grpSpPr>
        <p:cxnSp>
          <p:nvCxnSpPr>
            <p:cNvPr id="302" name="Gerade Verbindung 301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Gerade Verbindung 302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Gerade Verbindung 30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5" name="Gruppieren 304"/>
          <p:cNvGrpSpPr/>
          <p:nvPr/>
        </p:nvGrpSpPr>
        <p:grpSpPr>
          <a:xfrm>
            <a:off x="909646" y="826799"/>
            <a:ext cx="677000" cy="86293"/>
            <a:chOff x="2868920" y="5536746"/>
            <a:chExt cx="677000" cy="86293"/>
          </a:xfrm>
        </p:grpSpPr>
        <p:cxnSp>
          <p:nvCxnSpPr>
            <p:cNvPr id="306" name="Gerade Verbindung 305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Gerade Verbindung 306"/>
            <p:cNvCxnSpPr/>
            <p:nvPr/>
          </p:nvCxnSpPr>
          <p:spPr>
            <a:xfrm>
              <a:off x="3545920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Gerade Verbindung 307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9" name="Textfeld 308"/>
          <p:cNvSpPr txBox="1"/>
          <p:nvPr/>
        </p:nvSpPr>
        <p:spPr>
          <a:xfrm>
            <a:off x="1089530" y="700253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0" name="Textfeld 309"/>
          <p:cNvSpPr txBox="1"/>
          <p:nvPr/>
        </p:nvSpPr>
        <p:spPr>
          <a:xfrm>
            <a:off x="1256319" y="495526"/>
            <a:ext cx="3148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11" name="Gruppieren 310"/>
          <p:cNvGrpSpPr/>
          <p:nvPr/>
        </p:nvGrpSpPr>
        <p:grpSpPr>
          <a:xfrm>
            <a:off x="906997" y="623660"/>
            <a:ext cx="1022350" cy="87657"/>
            <a:chOff x="1447800" y="457200"/>
            <a:chExt cx="382775" cy="78771"/>
          </a:xfrm>
        </p:grpSpPr>
        <p:cxnSp>
          <p:nvCxnSpPr>
            <p:cNvPr id="312" name="Gerade Verbindung 311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Gerade Verbindung 312"/>
            <p:cNvCxnSpPr/>
            <p:nvPr/>
          </p:nvCxnSpPr>
          <p:spPr>
            <a:xfrm>
              <a:off x="18305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Gerade Verbindung 31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8" name="Gruppieren 637"/>
          <p:cNvGrpSpPr/>
          <p:nvPr/>
        </p:nvGrpSpPr>
        <p:grpSpPr>
          <a:xfrm>
            <a:off x="3115116" y="3002391"/>
            <a:ext cx="348714" cy="86854"/>
            <a:chOff x="1447800" y="457200"/>
            <a:chExt cx="383732" cy="63312"/>
          </a:xfrm>
        </p:grpSpPr>
        <p:cxnSp>
          <p:nvCxnSpPr>
            <p:cNvPr id="639" name="Gerade Verbindung 63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0" name="Gerade Verbindung 639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1" name="Gerade Verbindung 64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2" name="Textfeld 641"/>
          <p:cNvSpPr txBox="1"/>
          <p:nvPr/>
        </p:nvSpPr>
        <p:spPr>
          <a:xfrm>
            <a:off x="3156759" y="2878716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43" name="Gruppieren 642"/>
          <p:cNvGrpSpPr/>
          <p:nvPr/>
        </p:nvGrpSpPr>
        <p:grpSpPr>
          <a:xfrm>
            <a:off x="3114670" y="2890303"/>
            <a:ext cx="674448" cy="86293"/>
            <a:chOff x="2868920" y="5536746"/>
            <a:chExt cx="674448" cy="86293"/>
          </a:xfrm>
        </p:grpSpPr>
        <p:cxnSp>
          <p:nvCxnSpPr>
            <p:cNvPr id="644" name="Gerade Verbindung 64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5" name="Gerade Verbindung 644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6" name="Gerade Verbindung 64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7" name="Textfeld 646"/>
          <p:cNvSpPr txBox="1"/>
          <p:nvPr/>
        </p:nvSpPr>
        <p:spPr>
          <a:xfrm>
            <a:off x="3313606" y="2763757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8" name="Textfeld 647"/>
          <p:cNvSpPr txBox="1"/>
          <p:nvPr/>
        </p:nvSpPr>
        <p:spPr>
          <a:xfrm>
            <a:off x="3460232" y="2639360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49" name="Gruppieren 648"/>
          <p:cNvGrpSpPr/>
          <p:nvPr/>
        </p:nvGrpSpPr>
        <p:grpSpPr>
          <a:xfrm>
            <a:off x="3114670" y="2759543"/>
            <a:ext cx="1017609" cy="87657"/>
            <a:chOff x="1447800" y="457200"/>
            <a:chExt cx="381000" cy="78771"/>
          </a:xfrm>
        </p:grpSpPr>
        <p:cxnSp>
          <p:nvCxnSpPr>
            <p:cNvPr id="650" name="Gerade Verbindung 649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1" name="Gerade Verbindung 650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2" name="Gerade Verbindung 65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3" name="Gruppieren 652"/>
          <p:cNvGrpSpPr/>
          <p:nvPr/>
        </p:nvGrpSpPr>
        <p:grpSpPr>
          <a:xfrm>
            <a:off x="3455748" y="2604555"/>
            <a:ext cx="674448" cy="86293"/>
            <a:chOff x="2868920" y="5536746"/>
            <a:chExt cx="674448" cy="86293"/>
          </a:xfrm>
        </p:grpSpPr>
        <p:cxnSp>
          <p:nvCxnSpPr>
            <p:cNvPr id="654" name="Gerade Verbindung 65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5" name="Gerade Verbindung 654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6" name="Gerade Verbindung 65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7" name="Textfeld 656"/>
          <p:cNvSpPr txBox="1"/>
          <p:nvPr/>
        </p:nvSpPr>
        <p:spPr>
          <a:xfrm>
            <a:off x="3654684" y="2478009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58" name="Gruppieren 657"/>
          <p:cNvGrpSpPr/>
          <p:nvPr/>
        </p:nvGrpSpPr>
        <p:grpSpPr>
          <a:xfrm>
            <a:off x="3783396" y="2422005"/>
            <a:ext cx="348714" cy="86854"/>
            <a:chOff x="1447800" y="457200"/>
            <a:chExt cx="383732" cy="63312"/>
          </a:xfrm>
        </p:grpSpPr>
        <p:cxnSp>
          <p:nvCxnSpPr>
            <p:cNvPr id="659" name="Gerade Verbindung 65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0" name="Gerade Verbindung 659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1" name="Gerade Verbindung 66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2" name="Textfeld 661"/>
          <p:cNvSpPr txBox="1"/>
          <p:nvPr/>
        </p:nvSpPr>
        <p:spPr>
          <a:xfrm>
            <a:off x="3827355" y="2297876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3" name="Textfeld 662"/>
          <p:cNvSpPr txBox="1"/>
          <p:nvPr/>
        </p:nvSpPr>
        <p:spPr>
          <a:xfrm>
            <a:off x="2551868" y="2387769"/>
            <a:ext cx="97884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Chr10:012631455-012632051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  <a:p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2" name="Textfeld 681"/>
          <p:cNvSpPr txBox="1"/>
          <p:nvPr/>
        </p:nvSpPr>
        <p:spPr>
          <a:xfrm>
            <a:off x="4907194" y="2432592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Gabbr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3" name="Textfeld 682"/>
          <p:cNvSpPr txBox="1"/>
          <p:nvPr/>
        </p:nvSpPr>
        <p:spPr>
          <a:xfrm>
            <a:off x="5347654" y="2883041"/>
            <a:ext cx="3147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84" name="Gruppieren 683"/>
          <p:cNvGrpSpPr/>
          <p:nvPr/>
        </p:nvGrpSpPr>
        <p:grpSpPr>
          <a:xfrm>
            <a:off x="5324805" y="3007516"/>
            <a:ext cx="348714" cy="86854"/>
            <a:chOff x="1447800" y="457200"/>
            <a:chExt cx="383732" cy="63312"/>
          </a:xfrm>
        </p:grpSpPr>
        <p:cxnSp>
          <p:nvCxnSpPr>
            <p:cNvPr id="685" name="Gerade Verbindung 684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6" name="Gerade Verbindung 685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7" name="Gerade Verbindung 68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8" name="Gruppieren 687"/>
          <p:cNvGrpSpPr/>
          <p:nvPr/>
        </p:nvGrpSpPr>
        <p:grpSpPr>
          <a:xfrm>
            <a:off x="5327334" y="2858101"/>
            <a:ext cx="669905" cy="86293"/>
            <a:chOff x="2868920" y="5536746"/>
            <a:chExt cx="669905" cy="86293"/>
          </a:xfrm>
        </p:grpSpPr>
        <p:cxnSp>
          <p:nvCxnSpPr>
            <p:cNvPr id="689" name="Gerade Verbindung 688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0" name="Gerade Verbindung 689"/>
            <p:cNvCxnSpPr/>
            <p:nvPr/>
          </p:nvCxnSpPr>
          <p:spPr>
            <a:xfrm>
              <a:off x="3538344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1" name="Gerade Verbindung 690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2" name="Textfeld 691"/>
          <p:cNvSpPr txBox="1"/>
          <p:nvPr/>
        </p:nvSpPr>
        <p:spPr>
          <a:xfrm>
            <a:off x="5526270" y="273155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3" name="Textfeld 692"/>
          <p:cNvSpPr txBox="1"/>
          <p:nvPr/>
        </p:nvSpPr>
        <p:spPr>
          <a:xfrm>
            <a:off x="5670367" y="2576525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94" name="Gruppieren 693"/>
          <p:cNvGrpSpPr/>
          <p:nvPr/>
        </p:nvGrpSpPr>
        <p:grpSpPr>
          <a:xfrm>
            <a:off x="5324805" y="2708584"/>
            <a:ext cx="1017609" cy="87657"/>
            <a:chOff x="1447800" y="457200"/>
            <a:chExt cx="381000" cy="78771"/>
          </a:xfrm>
        </p:grpSpPr>
        <p:cxnSp>
          <p:nvCxnSpPr>
            <p:cNvPr id="695" name="Gerade Verbindung 694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6" name="Gerade Verbindung 695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7" name="Gerade Verbindung 69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8" name="Textfeld 697"/>
          <p:cNvSpPr txBox="1"/>
          <p:nvPr/>
        </p:nvSpPr>
        <p:spPr>
          <a:xfrm>
            <a:off x="7591477" y="2984956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99" name="Gruppieren 698"/>
          <p:cNvGrpSpPr/>
          <p:nvPr/>
        </p:nvGrpSpPr>
        <p:grpSpPr>
          <a:xfrm>
            <a:off x="7536862" y="3103493"/>
            <a:ext cx="348714" cy="86854"/>
            <a:chOff x="1447800" y="457200"/>
            <a:chExt cx="383732" cy="63312"/>
          </a:xfrm>
        </p:grpSpPr>
        <p:cxnSp>
          <p:nvCxnSpPr>
            <p:cNvPr id="700" name="Gerade Verbindung 699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1" name="Gerade Verbindung 700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2" name="Gerade Verbindung 70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3" name="Gruppieren 702"/>
          <p:cNvGrpSpPr/>
          <p:nvPr/>
        </p:nvGrpSpPr>
        <p:grpSpPr>
          <a:xfrm>
            <a:off x="7539831" y="2975014"/>
            <a:ext cx="669905" cy="86293"/>
            <a:chOff x="2868920" y="5536746"/>
            <a:chExt cx="669905" cy="86293"/>
          </a:xfrm>
        </p:grpSpPr>
        <p:cxnSp>
          <p:nvCxnSpPr>
            <p:cNvPr id="704" name="Gerade Verbindung 70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5" name="Gerade Verbindung 704"/>
            <p:cNvCxnSpPr/>
            <p:nvPr/>
          </p:nvCxnSpPr>
          <p:spPr>
            <a:xfrm>
              <a:off x="3538344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6" name="Gerade Verbindung 70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7" name="Textfeld 706"/>
          <p:cNvSpPr txBox="1"/>
          <p:nvPr/>
        </p:nvSpPr>
        <p:spPr>
          <a:xfrm>
            <a:off x="7738767" y="284846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8" name="Textfeld 707"/>
          <p:cNvSpPr txBox="1"/>
          <p:nvPr/>
        </p:nvSpPr>
        <p:spPr>
          <a:xfrm>
            <a:off x="7882681" y="2726212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09" name="Gruppieren 708"/>
          <p:cNvGrpSpPr/>
          <p:nvPr/>
        </p:nvGrpSpPr>
        <p:grpSpPr>
          <a:xfrm>
            <a:off x="7537119" y="2846395"/>
            <a:ext cx="1017609" cy="87657"/>
            <a:chOff x="1447800" y="457200"/>
            <a:chExt cx="381000" cy="78771"/>
          </a:xfrm>
        </p:grpSpPr>
        <p:cxnSp>
          <p:nvCxnSpPr>
            <p:cNvPr id="710" name="Gerade Verbindung 709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1" name="Gerade Verbindung 710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2" name="Gerade Verbindung 71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3" name="Gruppieren 712"/>
          <p:cNvGrpSpPr/>
          <p:nvPr/>
        </p:nvGrpSpPr>
        <p:grpSpPr>
          <a:xfrm>
            <a:off x="7884823" y="2695334"/>
            <a:ext cx="669905" cy="86293"/>
            <a:chOff x="2868920" y="5536746"/>
            <a:chExt cx="669905" cy="86293"/>
          </a:xfrm>
        </p:grpSpPr>
        <p:cxnSp>
          <p:nvCxnSpPr>
            <p:cNvPr id="714" name="Gerade Verbindung 71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5" name="Gerade Verbindung 714"/>
            <p:cNvCxnSpPr/>
            <p:nvPr/>
          </p:nvCxnSpPr>
          <p:spPr>
            <a:xfrm>
              <a:off x="3538344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6" name="Gerade Verbindung 71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7" name="Textfeld 716"/>
          <p:cNvSpPr txBox="1"/>
          <p:nvPr/>
        </p:nvSpPr>
        <p:spPr>
          <a:xfrm>
            <a:off x="8119387" y="256878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18" name="Gruppieren 717"/>
          <p:cNvGrpSpPr/>
          <p:nvPr/>
        </p:nvGrpSpPr>
        <p:grpSpPr>
          <a:xfrm>
            <a:off x="8203872" y="2498259"/>
            <a:ext cx="348714" cy="86854"/>
            <a:chOff x="1447800" y="457200"/>
            <a:chExt cx="383732" cy="63312"/>
          </a:xfrm>
        </p:grpSpPr>
        <p:cxnSp>
          <p:nvCxnSpPr>
            <p:cNvPr id="719" name="Gerade Verbindung 71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0" name="Gerade Verbindung 719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1" name="Gerade Verbindung 72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22" name="Textfeld 721"/>
          <p:cNvSpPr txBox="1"/>
          <p:nvPr/>
        </p:nvSpPr>
        <p:spPr>
          <a:xfrm>
            <a:off x="8267700" y="2365058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3" name="Textfeld 722"/>
          <p:cNvSpPr txBox="1"/>
          <p:nvPr/>
        </p:nvSpPr>
        <p:spPr>
          <a:xfrm>
            <a:off x="7114879" y="2432592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Gm1679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7" name="Textfeld 576"/>
          <p:cNvSpPr txBox="1"/>
          <p:nvPr/>
        </p:nvSpPr>
        <p:spPr>
          <a:xfrm>
            <a:off x="488466" y="2438400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2410137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78" name="Gruppieren 577"/>
          <p:cNvGrpSpPr/>
          <p:nvPr/>
        </p:nvGrpSpPr>
        <p:grpSpPr>
          <a:xfrm>
            <a:off x="908470" y="3114511"/>
            <a:ext cx="348714" cy="86854"/>
            <a:chOff x="1447800" y="457200"/>
            <a:chExt cx="383732" cy="63312"/>
          </a:xfrm>
        </p:grpSpPr>
        <p:cxnSp>
          <p:nvCxnSpPr>
            <p:cNvPr id="579" name="Gerade Verbindung 57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0" name="Gerade Verbindung 579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1" name="Gerade Verbindung 58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2" name="Textfeld 581"/>
          <p:cNvSpPr txBox="1"/>
          <p:nvPr/>
        </p:nvSpPr>
        <p:spPr>
          <a:xfrm>
            <a:off x="957226" y="2981310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83" name="Gruppieren 582"/>
          <p:cNvGrpSpPr/>
          <p:nvPr/>
        </p:nvGrpSpPr>
        <p:grpSpPr>
          <a:xfrm>
            <a:off x="910288" y="2973359"/>
            <a:ext cx="674448" cy="86293"/>
            <a:chOff x="2868920" y="5536746"/>
            <a:chExt cx="674448" cy="86293"/>
          </a:xfrm>
        </p:grpSpPr>
        <p:cxnSp>
          <p:nvCxnSpPr>
            <p:cNvPr id="584" name="Gerade Verbindung 58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5" name="Gerade Verbindung 584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6" name="Gerade Verbindung 58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7" name="Textfeld 586"/>
          <p:cNvSpPr txBox="1"/>
          <p:nvPr/>
        </p:nvSpPr>
        <p:spPr>
          <a:xfrm>
            <a:off x="1109224" y="2846813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8" name="Textfeld 587"/>
          <p:cNvSpPr txBox="1"/>
          <p:nvPr/>
        </p:nvSpPr>
        <p:spPr>
          <a:xfrm>
            <a:off x="1255593" y="2709851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89" name="Gruppieren 588"/>
          <p:cNvGrpSpPr/>
          <p:nvPr/>
        </p:nvGrpSpPr>
        <p:grpSpPr>
          <a:xfrm>
            <a:off x="910031" y="2830034"/>
            <a:ext cx="1017609" cy="87657"/>
            <a:chOff x="1447800" y="457200"/>
            <a:chExt cx="381000" cy="78771"/>
          </a:xfrm>
        </p:grpSpPr>
        <p:cxnSp>
          <p:nvCxnSpPr>
            <p:cNvPr id="590" name="Gerade Verbindung 589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1" name="Gerade Verbindung 590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2" name="Gerade Verbindung 59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3" name="Gruppieren 592"/>
          <p:cNvGrpSpPr/>
          <p:nvPr/>
        </p:nvGrpSpPr>
        <p:grpSpPr>
          <a:xfrm>
            <a:off x="1257955" y="2683989"/>
            <a:ext cx="674448" cy="86293"/>
            <a:chOff x="2868920" y="5536746"/>
            <a:chExt cx="674448" cy="86293"/>
          </a:xfrm>
        </p:grpSpPr>
        <p:cxnSp>
          <p:nvCxnSpPr>
            <p:cNvPr id="594" name="Gerade Verbindung 59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5" name="Gerade Verbindung 594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6" name="Gerade Verbindung 59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7" name="Textfeld 596"/>
          <p:cNvSpPr txBox="1"/>
          <p:nvPr/>
        </p:nvSpPr>
        <p:spPr>
          <a:xfrm>
            <a:off x="1480643" y="2563381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98" name="Gruppieren 597"/>
          <p:cNvGrpSpPr/>
          <p:nvPr/>
        </p:nvGrpSpPr>
        <p:grpSpPr>
          <a:xfrm>
            <a:off x="1583606" y="2490630"/>
            <a:ext cx="348714" cy="86854"/>
            <a:chOff x="1447800" y="457200"/>
            <a:chExt cx="383732" cy="63312"/>
          </a:xfrm>
        </p:grpSpPr>
        <p:cxnSp>
          <p:nvCxnSpPr>
            <p:cNvPr id="599" name="Gerade Verbindung 59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0" name="Gerade Verbindung 599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1" name="Gerade Verbindung 60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2" name="Textfeld 601"/>
          <p:cNvSpPr txBox="1"/>
          <p:nvPr/>
        </p:nvSpPr>
        <p:spPr>
          <a:xfrm>
            <a:off x="1632362" y="2357429"/>
            <a:ext cx="419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7" name="Textfeld 776"/>
          <p:cNvSpPr txBox="1"/>
          <p:nvPr/>
        </p:nvSpPr>
        <p:spPr>
          <a:xfrm>
            <a:off x="1253246" y="4764716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78" name="Gruppieren 777"/>
          <p:cNvGrpSpPr/>
          <p:nvPr/>
        </p:nvGrpSpPr>
        <p:grpSpPr>
          <a:xfrm>
            <a:off x="922103" y="4895036"/>
            <a:ext cx="1017609" cy="87657"/>
            <a:chOff x="1447800" y="457200"/>
            <a:chExt cx="381000" cy="78771"/>
          </a:xfrm>
        </p:grpSpPr>
        <p:cxnSp>
          <p:nvCxnSpPr>
            <p:cNvPr id="779" name="Gerade Verbindung 778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0" name="Gerade Verbindung 779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1" name="Gerade Verbindung 78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87" name="Gruppieren 786"/>
          <p:cNvGrpSpPr/>
          <p:nvPr/>
        </p:nvGrpSpPr>
        <p:grpSpPr>
          <a:xfrm>
            <a:off x="919022" y="5112530"/>
            <a:ext cx="674448" cy="86293"/>
            <a:chOff x="2868920" y="5536746"/>
            <a:chExt cx="674448" cy="86293"/>
          </a:xfrm>
        </p:grpSpPr>
        <p:cxnSp>
          <p:nvCxnSpPr>
            <p:cNvPr id="788" name="Gerade Verbindung 787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9" name="Gerade Verbindung 788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0" name="Gerade Verbindung 789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1" name="Textfeld 790"/>
          <p:cNvSpPr txBox="1"/>
          <p:nvPr/>
        </p:nvSpPr>
        <p:spPr>
          <a:xfrm>
            <a:off x="1145254" y="4985984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7" name="Textfeld 806"/>
          <p:cNvSpPr txBox="1"/>
          <p:nvPr/>
        </p:nvSpPr>
        <p:spPr>
          <a:xfrm>
            <a:off x="491320" y="4495800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Myh14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8" name="Textfeld 807"/>
          <p:cNvSpPr txBox="1"/>
          <p:nvPr/>
        </p:nvSpPr>
        <p:spPr>
          <a:xfrm>
            <a:off x="3159017" y="4934328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09" name="Gruppieren 808"/>
          <p:cNvGrpSpPr/>
          <p:nvPr/>
        </p:nvGrpSpPr>
        <p:grpSpPr>
          <a:xfrm>
            <a:off x="3114180" y="5060182"/>
            <a:ext cx="348714" cy="86854"/>
            <a:chOff x="1447800" y="457200"/>
            <a:chExt cx="383732" cy="63312"/>
          </a:xfrm>
        </p:grpSpPr>
        <p:cxnSp>
          <p:nvCxnSpPr>
            <p:cNvPr id="810" name="Gerade Verbindung 809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1" name="Gerade Verbindung 810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2" name="Gerade Verbindung 81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3" name="Gruppieren 812"/>
          <p:cNvGrpSpPr/>
          <p:nvPr/>
        </p:nvGrpSpPr>
        <p:grpSpPr>
          <a:xfrm>
            <a:off x="3115832" y="4919126"/>
            <a:ext cx="674448" cy="86293"/>
            <a:chOff x="2868920" y="5536746"/>
            <a:chExt cx="674448" cy="86293"/>
          </a:xfrm>
        </p:grpSpPr>
        <p:cxnSp>
          <p:nvCxnSpPr>
            <p:cNvPr id="814" name="Gerade Verbindung 81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5" name="Gerade Verbindung 814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6" name="Gerade Verbindung 81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17" name="Textfeld 816"/>
          <p:cNvSpPr txBox="1"/>
          <p:nvPr/>
        </p:nvSpPr>
        <p:spPr>
          <a:xfrm>
            <a:off x="3338084" y="4792580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8" name="Textfeld 817"/>
          <p:cNvSpPr txBox="1"/>
          <p:nvPr/>
        </p:nvSpPr>
        <p:spPr>
          <a:xfrm>
            <a:off x="3473679" y="4626601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19" name="Gruppieren 818"/>
          <p:cNvGrpSpPr/>
          <p:nvPr/>
        </p:nvGrpSpPr>
        <p:grpSpPr>
          <a:xfrm>
            <a:off x="3117663" y="4759759"/>
            <a:ext cx="1017609" cy="87657"/>
            <a:chOff x="1447800" y="457200"/>
            <a:chExt cx="381000" cy="78771"/>
          </a:xfrm>
        </p:grpSpPr>
        <p:cxnSp>
          <p:nvCxnSpPr>
            <p:cNvPr id="820" name="Gerade Verbindung 819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1" name="Gerade Verbindung 820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2" name="Gerade Verbindung 82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23" name="Textfeld 822"/>
          <p:cNvSpPr txBox="1"/>
          <p:nvPr/>
        </p:nvSpPr>
        <p:spPr>
          <a:xfrm>
            <a:off x="2701284" y="4495800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Il17re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4" name="Textfeld 823"/>
          <p:cNvSpPr txBox="1"/>
          <p:nvPr/>
        </p:nvSpPr>
        <p:spPr>
          <a:xfrm>
            <a:off x="5352075" y="4908832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25" name="Gruppieren 824"/>
          <p:cNvGrpSpPr/>
          <p:nvPr/>
        </p:nvGrpSpPr>
        <p:grpSpPr>
          <a:xfrm>
            <a:off x="5327334" y="5034686"/>
            <a:ext cx="348714" cy="86854"/>
            <a:chOff x="1447800" y="457200"/>
            <a:chExt cx="383732" cy="63312"/>
          </a:xfrm>
        </p:grpSpPr>
        <p:cxnSp>
          <p:nvCxnSpPr>
            <p:cNvPr id="826" name="Gerade Verbindung 825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7" name="Gerade Verbindung 826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8" name="Gerade Verbindung 827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9" name="Gruppieren 828"/>
          <p:cNvGrpSpPr/>
          <p:nvPr/>
        </p:nvGrpSpPr>
        <p:grpSpPr>
          <a:xfrm>
            <a:off x="5327799" y="4877114"/>
            <a:ext cx="674448" cy="86293"/>
            <a:chOff x="2868920" y="5536746"/>
            <a:chExt cx="674448" cy="86293"/>
          </a:xfrm>
        </p:grpSpPr>
        <p:cxnSp>
          <p:nvCxnSpPr>
            <p:cNvPr id="830" name="Gerade Verbindung 829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1" name="Gerade Verbindung 830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2" name="Gerade Verbindung 831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33" name="Textfeld 832"/>
          <p:cNvSpPr txBox="1"/>
          <p:nvPr/>
        </p:nvSpPr>
        <p:spPr>
          <a:xfrm>
            <a:off x="5492611" y="475056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4" name="Textfeld 833"/>
          <p:cNvSpPr txBox="1"/>
          <p:nvPr/>
        </p:nvSpPr>
        <p:spPr>
          <a:xfrm>
            <a:off x="5643595" y="461838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35" name="Gruppieren 834"/>
          <p:cNvGrpSpPr/>
          <p:nvPr/>
        </p:nvGrpSpPr>
        <p:grpSpPr>
          <a:xfrm>
            <a:off x="5327334" y="4743587"/>
            <a:ext cx="1017609" cy="87657"/>
            <a:chOff x="1447800" y="457200"/>
            <a:chExt cx="381000" cy="78771"/>
          </a:xfrm>
        </p:grpSpPr>
        <p:cxnSp>
          <p:nvCxnSpPr>
            <p:cNvPr id="836" name="Gerade Verbindung 835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7" name="Gerade Verbindung 836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8" name="Gerade Verbindung 837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9" name="Gruppieren 838"/>
          <p:cNvGrpSpPr/>
          <p:nvPr/>
        </p:nvGrpSpPr>
        <p:grpSpPr>
          <a:xfrm>
            <a:off x="5666463" y="4588226"/>
            <a:ext cx="669905" cy="86293"/>
            <a:chOff x="2868920" y="5536746"/>
            <a:chExt cx="669905" cy="86293"/>
          </a:xfrm>
        </p:grpSpPr>
        <p:cxnSp>
          <p:nvCxnSpPr>
            <p:cNvPr id="840" name="Gerade Verbindung 839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1" name="Gerade Verbindung 840"/>
            <p:cNvCxnSpPr/>
            <p:nvPr/>
          </p:nvCxnSpPr>
          <p:spPr>
            <a:xfrm>
              <a:off x="3538344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2" name="Gerade Verbindung 841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43" name="Textfeld 842"/>
          <p:cNvSpPr txBox="1"/>
          <p:nvPr/>
        </p:nvSpPr>
        <p:spPr>
          <a:xfrm>
            <a:off x="5861419" y="4461680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4" name="Textfeld 843"/>
          <p:cNvSpPr txBox="1"/>
          <p:nvPr/>
        </p:nvSpPr>
        <p:spPr>
          <a:xfrm>
            <a:off x="4907194" y="4495800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Mapk11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5" name="Textfeld 844"/>
          <p:cNvSpPr txBox="1"/>
          <p:nvPr/>
        </p:nvSpPr>
        <p:spPr>
          <a:xfrm>
            <a:off x="7111149" y="4495800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Mdga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6" name="Textfeld 845"/>
          <p:cNvSpPr txBox="1"/>
          <p:nvPr/>
        </p:nvSpPr>
        <p:spPr>
          <a:xfrm>
            <a:off x="7555560" y="4828792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47" name="Gruppieren 846"/>
          <p:cNvGrpSpPr/>
          <p:nvPr/>
        </p:nvGrpSpPr>
        <p:grpSpPr>
          <a:xfrm>
            <a:off x="7530819" y="4954646"/>
            <a:ext cx="348714" cy="86854"/>
            <a:chOff x="1447800" y="457200"/>
            <a:chExt cx="383732" cy="63312"/>
          </a:xfrm>
        </p:grpSpPr>
        <p:cxnSp>
          <p:nvCxnSpPr>
            <p:cNvPr id="848" name="Gerade Verbindung 847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9" name="Gerade Verbindung 848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0" name="Gerade Verbindung 84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1" name="Gruppieren 850"/>
          <p:cNvGrpSpPr/>
          <p:nvPr/>
        </p:nvGrpSpPr>
        <p:grpSpPr>
          <a:xfrm>
            <a:off x="7526279" y="4812986"/>
            <a:ext cx="674448" cy="86293"/>
            <a:chOff x="2868920" y="5536746"/>
            <a:chExt cx="674448" cy="86293"/>
          </a:xfrm>
        </p:grpSpPr>
        <p:cxnSp>
          <p:nvCxnSpPr>
            <p:cNvPr id="852" name="Gerade Verbindung 851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3" name="Gerade Verbindung 852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4" name="Gerade Verbindung 853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55" name="Textfeld 854"/>
          <p:cNvSpPr txBox="1"/>
          <p:nvPr/>
        </p:nvSpPr>
        <p:spPr>
          <a:xfrm>
            <a:off x="7704739" y="4678489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6" name="Textfeld 855"/>
          <p:cNvSpPr txBox="1"/>
          <p:nvPr/>
        </p:nvSpPr>
        <p:spPr>
          <a:xfrm>
            <a:off x="7908116" y="4550314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57" name="Gruppieren 856"/>
          <p:cNvGrpSpPr/>
          <p:nvPr/>
        </p:nvGrpSpPr>
        <p:grpSpPr>
          <a:xfrm>
            <a:off x="7530439" y="4675521"/>
            <a:ext cx="1017609" cy="87657"/>
            <a:chOff x="1447800" y="457200"/>
            <a:chExt cx="381000" cy="78771"/>
          </a:xfrm>
        </p:grpSpPr>
        <p:cxnSp>
          <p:nvCxnSpPr>
            <p:cNvPr id="858" name="Gerade Verbindung 857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9" name="Gerade Verbindung 858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0" name="Gerade Verbindung 85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814"/>
          <a:stretch/>
        </p:blipFill>
        <p:spPr bwMode="auto">
          <a:xfrm>
            <a:off x="4796047" y="541325"/>
            <a:ext cx="1774967" cy="11045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814"/>
          <a:stretch/>
        </p:blipFill>
        <p:spPr bwMode="auto">
          <a:xfrm>
            <a:off x="7004853" y="541325"/>
            <a:ext cx="1774967" cy="11045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950"/>
          <a:stretch/>
        </p:blipFill>
        <p:spPr bwMode="auto">
          <a:xfrm>
            <a:off x="381000" y="2667000"/>
            <a:ext cx="1774967" cy="11019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950"/>
          <a:stretch/>
        </p:blipFill>
        <p:spPr bwMode="auto">
          <a:xfrm>
            <a:off x="2586112" y="2667000"/>
            <a:ext cx="1774967" cy="11019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950"/>
          <a:stretch/>
        </p:blipFill>
        <p:spPr bwMode="auto">
          <a:xfrm>
            <a:off x="4796047" y="2667000"/>
            <a:ext cx="1774968" cy="11019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950"/>
          <a:stretch/>
        </p:blipFill>
        <p:spPr bwMode="auto">
          <a:xfrm>
            <a:off x="7004853" y="2667000"/>
            <a:ext cx="1774967" cy="11019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563"/>
          <a:stretch/>
        </p:blipFill>
        <p:spPr bwMode="auto">
          <a:xfrm>
            <a:off x="381000" y="4786150"/>
            <a:ext cx="1774967" cy="108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563"/>
          <a:stretch/>
        </p:blipFill>
        <p:spPr bwMode="auto">
          <a:xfrm>
            <a:off x="2586112" y="4786150"/>
            <a:ext cx="1774967" cy="108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8" name="Picture 12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563"/>
          <a:stretch/>
        </p:blipFill>
        <p:spPr bwMode="auto">
          <a:xfrm>
            <a:off x="4796047" y="4786150"/>
            <a:ext cx="1774967" cy="108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9" name="Picture 13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563"/>
          <a:stretch/>
        </p:blipFill>
        <p:spPr bwMode="auto">
          <a:xfrm>
            <a:off x="7004853" y="4786150"/>
            <a:ext cx="1774967" cy="108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38" name="Gruppieren 237"/>
          <p:cNvGrpSpPr/>
          <p:nvPr/>
        </p:nvGrpSpPr>
        <p:grpSpPr>
          <a:xfrm>
            <a:off x="228600" y="1415996"/>
            <a:ext cx="1517339" cy="1005403"/>
            <a:chOff x="224923" y="1419259"/>
            <a:chExt cx="1517339" cy="1005403"/>
          </a:xfrm>
        </p:grpSpPr>
        <p:sp>
          <p:nvSpPr>
            <p:cNvPr id="239" name="Textfeld 238"/>
            <p:cNvSpPr txBox="1"/>
            <p:nvPr/>
          </p:nvSpPr>
          <p:spPr>
            <a:xfrm rot="18974389">
              <a:off x="224923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40" name="Rechteck 239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41" name="Rechteck 240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Rechteck 241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3" name="Gruppieren 242"/>
          <p:cNvGrpSpPr/>
          <p:nvPr/>
        </p:nvGrpSpPr>
        <p:grpSpPr>
          <a:xfrm>
            <a:off x="2438400" y="1415996"/>
            <a:ext cx="1509388" cy="1005403"/>
            <a:chOff x="232874" y="1419259"/>
            <a:chExt cx="1509388" cy="1005403"/>
          </a:xfrm>
        </p:grpSpPr>
        <p:sp>
          <p:nvSpPr>
            <p:cNvPr id="244" name="Textfeld 243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45" name="Rechteck 244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46" name="Rechteck 245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Rechteck 246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8" name="Gruppieren 247"/>
          <p:cNvGrpSpPr/>
          <p:nvPr/>
        </p:nvGrpSpPr>
        <p:grpSpPr>
          <a:xfrm>
            <a:off x="4654861" y="1415996"/>
            <a:ext cx="1509388" cy="1005403"/>
            <a:chOff x="232874" y="1419259"/>
            <a:chExt cx="1509388" cy="1005403"/>
          </a:xfrm>
        </p:grpSpPr>
        <p:sp>
          <p:nvSpPr>
            <p:cNvPr id="249" name="Textfeld 248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50" name="Rechteck 249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51" name="Rechteck 250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2" name="Rechteck 251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53" name="Gruppieren 252"/>
          <p:cNvGrpSpPr/>
          <p:nvPr/>
        </p:nvGrpSpPr>
        <p:grpSpPr>
          <a:xfrm>
            <a:off x="6872612" y="1415996"/>
            <a:ext cx="1509388" cy="1005403"/>
            <a:chOff x="232874" y="1419259"/>
            <a:chExt cx="1509388" cy="1005403"/>
          </a:xfrm>
        </p:grpSpPr>
        <p:sp>
          <p:nvSpPr>
            <p:cNvPr id="254" name="Textfeld 253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55" name="Rechteck 254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56" name="Rechteck 255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7" name="Rechteck 256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58" name="Gruppieren 257"/>
          <p:cNvGrpSpPr/>
          <p:nvPr/>
        </p:nvGrpSpPr>
        <p:grpSpPr>
          <a:xfrm>
            <a:off x="6872612" y="3548265"/>
            <a:ext cx="1509388" cy="1005403"/>
            <a:chOff x="232874" y="1419259"/>
            <a:chExt cx="1509388" cy="1005403"/>
          </a:xfrm>
        </p:grpSpPr>
        <p:sp>
          <p:nvSpPr>
            <p:cNvPr id="259" name="Textfeld 258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60" name="Rechteck 259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n=7)</a:t>
              </a:r>
            </a:p>
          </p:txBody>
        </p:sp>
        <p:sp>
          <p:nvSpPr>
            <p:cNvPr id="261" name="Rechteck 260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Rechteck 261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3" name="Gruppieren 262"/>
          <p:cNvGrpSpPr/>
          <p:nvPr/>
        </p:nvGrpSpPr>
        <p:grpSpPr>
          <a:xfrm>
            <a:off x="4654861" y="3548265"/>
            <a:ext cx="1509388" cy="1005403"/>
            <a:chOff x="232874" y="1419259"/>
            <a:chExt cx="1509388" cy="1005403"/>
          </a:xfrm>
        </p:grpSpPr>
        <p:sp>
          <p:nvSpPr>
            <p:cNvPr id="264" name="Textfeld 263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65" name="Rechteck 264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6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Rechteck 265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7" name="Rechteck 266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6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8" name="Gruppieren 267"/>
          <p:cNvGrpSpPr/>
          <p:nvPr/>
        </p:nvGrpSpPr>
        <p:grpSpPr>
          <a:xfrm>
            <a:off x="2438400" y="3548265"/>
            <a:ext cx="1509388" cy="1005403"/>
            <a:chOff x="232874" y="1419259"/>
            <a:chExt cx="1509388" cy="1005403"/>
          </a:xfrm>
        </p:grpSpPr>
        <p:sp>
          <p:nvSpPr>
            <p:cNvPr id="269" name="Textfeld 268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70" name="Rechteck 269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Rechteck 270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Rechteck 271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73" name="Gruppieren 272"/>
          <p:cNvGrpSpPr/>
          <p:nvPr/>
        </p:nvGrpSpPr>
        <p:grpSpPr>
          <a:xfrm>
            <a:off x="228600" y="3548265"/>
            <a:ext cx="1509388" cy="1005403"/>
            <a:chOff x="232874" y="1419259"/>
            <a:chExt cx="1509388" cy="1005403"/>
          </a:xfrm>
        </p:grpSpPr>
        <p:sp>
          <p:nvSpPr>
            <p:cNvPr id="274" name="Textfeld 273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75" name="Rechteck 274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" name="Rechteck 275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7" name="Rechteck 276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78" name="Gruppieren 277"/>
          <p:cNvGrpSpPr/>
          <p:nvPr/>
        </p:nvGrpSpPr>
        <p:grpSpPr>
          <a:xfrm>
            <a:off x="228600" y="5668393"/>
            <a:ext cx="1509388" cy="1005403"/>
            <a:chOff x="232874" y="1419259"/>
            <a:chExt cx="1509388" cy="1005403"/>
          </a:xfrm>
        </p:grpSpPr>
        <p:sp>
          <p:nvSpPr>
            <p:cNvPr id="279" name="Textfeld 278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80" name="Rechteck 279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1" name="Rechteck 280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Rechteck 281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3" name="Gruppieren 282"/>
          <p:cNvGrpSpPr/>
          <p:nvPr/>
        </p:nvGrpSpPr>
        <p:grpSpPr>
          <a:xfrm>
            <a:off x="2438400" y="5668393"/>
            <a:ext cx="1509388" cy="1005403"/>
            <a:chOff x="232874" y="1419259"/>
            <a:chExt cx="1509388" cy="1005403"/>
          </a:xfrm>
        </p:grpSpPr>
        <p:sp>
          <p:nvSpPr>
            <p:cNvPr id="284" name="Textfeld 283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85" name="Rechteck 284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6" name="Rechteck 285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" name="Rechteck 286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8" name="Gruppieren 287"/>
          <p:cNvGrpSpPr/>
          <p:nvPr/>
        </p:nvGrpSpPr>
        <p:grpSpPr>
          <a:xfrm>
            <a:off x="4654861" y="5668393"/>
            <a:ext cx="1509388" cy="1005403"/>
            <a:chOff x="232874" y="1419259"/>
            <a:chExt cx="1509388" cy="1005403"/>
          </a:xfrm>
        </p:grpSpPr>
        <p:sp>
          <p:nvSpPr>
            <p:cNvPr id="289" name="Textfeld 288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90" name="Rechteck 289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Rechteck 290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Rechteck 291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93" name="Gruppieren 292"/>
          <p:cNvGrpSpPr/>
          <p:nvPr/>
        </p:nvGrpSpPr>
        <p:grpSpPr>
          <a:xfrm>
            <a:off x="6872612" y="5668393"/>
            <a:ext cx="1509388" cy="1005403"/>
            <a:chOff x="232874" y="1419259"/>
            <a:chExt cx="1509388" cy="1005403"/>
          </a:xfrm>
        </p:grpSpPr>
        <p:sp>
          <p:nvSpPr>
            <p:cNvPr id="294" name="Textfeld 293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95" name="Rechteck 294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Rechteck 295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Rechteck 296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048723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6" name="Picture 2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356"/>
          <a:stretch/>
        </p:blipFill>
        <p:spPr bwMode="auto">
          <a:xfrm>
            <a:off x="7003496" y="4790028"/>
            <a:ext cx="1774967" cy="1093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2" name="Textfeld 61"/>
          <p:cNvSpPr txBox="1"/>
          <p:nvPr/>
        </p:nvSpPr>
        <p:spPr>
          <a:xfrm>
            <a:off x="516616" y="31313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Ltbp3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933208" y="527976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4" name="Gruppieren 63"/>
          <p:cNvGrpSpPr/>
          <p:nvPr/>
        </p:nvGrpSpPr>
        <p:grpSpPr>
          <a:xfrm>
            <a:off x="917416" y="641342"/>
            <a:ext cx="348714" cy="86854"/>
            <a:chOff x="1447800" y="457200"/>
            <a:chExt cx="383732" cy="63312"/>
          </a:xfrm>
        </p:grpSpPr>
        <p:cxnSp>
          <p:nvCxnSpPr>
            <p:cNvPr id="65" name="Gerade Verbindung 64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Gerade Verbindung 65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Gerade Verbindung 6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uppieren 67"/>
          <p:cNvGrpSpPr/>
          <p:nvPr/>
        </p:nvGrpSpPr>
        <p:grpSpPr>
          <a:xfrm>
            <a:off x="915743" y="475265"/>
            <a:ext cx="674448" cy="86293"/>
            <a:chOff x="2868920" y="5536746"/>
            <a:chExt cx="674448" cy="86293"/>
          </a:xfrm>
        </p:grpSpPr>
        <p:cxnSp>
          <p:nvCxnSpPr>
            <p:cNvPr id="69" name="Gerade Verbindung 68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Gerade Verbindung 69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 Verbindung 70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2" name="Textfeld 71"/>
          <p:cNvSpPr txBox="1"/>
          <p:nvPr/>
        </p:nvSpPr>
        <p:spPr>
          <a:xfrm>
            <a:off x="1119002" y="359094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1263247" y="16764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4" name="Gruppieren 73"/>
          <p:cNvGrpSpPr/>
          <p:nvPr/>
        </p:nvGrpSpPr>
        <p:grpSpPr>
          <a:xfrm>
            <a:off x="915743" y="303472"/>
            <a:ext cx="1017609" cy="87657"/>
            <a:chOff x="1447800" y="457200"/>
            <a:chExt cx="381000" cy="78771"/>
          </a:xfrm>
        </p:grpSpPr>
        <p:cxnSp>
          <p:nvCxnSpPr>
            <p:cNvPr id="75" name="Gerade Verbindung 74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Gerade Verbindung 75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Gerade Verbindung 7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Textfeld 113"/>
          <p:cNvSpPr txBox="1"/>
          <p:nvPr/>
        </p:nvSpPr>
        <p:spPr>
          <a:xfrm>
            <a:off x="2692658" y="31313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Map3k6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3141783" y="669616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6" name="Gruppieren 115"/>
          <p:cNvGrpSpPr/>
          <p:nvPr/>
        </p:nvGrpSpPr>
        <p:grpSpPr>
          <a:xfrm>
            <a:off x="3117042" y="795470"/>
            <a:ext cx="348714" cy="86854"/>
            <a:chOff x="1447800" y="457200"/>
            <a:chExt cx="383732" cy="63312"/>
          </a:xfrm>
        </p:grpSpPr>
        <p:cxnSp>
          <p:nvCxnSpPr>
            <p:cNvPr id="117" name="Gerade Verbindung 116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Gerade Verbindung 117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Gerade Verbindung 11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0" name="Gruppieren 119"/>
          <p:cNvGrpSpPr/>
          <p:nvPr/>
        </p:nvGrpSpPr>
        <p:grpSpPr>
          <a:xfrm>
            <a:off x="3117042" y="643762"/>
            <a:ext cx="674448" cy="86293"/>
            <a:chOff x="2868920" y="5536746"/>
            <a:chExt cx="674448" cy="86293"/>
          </a:xfrm>
        </p:grpSpPr>
        <p:cxnSp>
          <p:nvCxnSpPr>
            <p:cNvPr id="121" name="Gerade Verbindung 120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Gerade Verbindung 121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Gerade Verbindung 122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4" name="Textfeld 123"/>
          <p:cNvSpPr txBox="1"/>
          <p:nvPr/>
        </p:nvSpPr>
        <p:spPr>
          <a:xfrm>
            <a:off x="3311998" y="517216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3439996" y="407262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6" name="Gruppieren 125"/>
          <p:cNvGrpSpPr/>
          <p:nvPr/>
        </p:nvGrpSpPr>
        <p:grpSpPr>
          <a:xfrm>
            <a:off x="3117663" y="532469"/>
            <a:ext cx="1017609" cy="87657"/>
            <a:chOff x="1447800" y="457200"/>
            <a:chExt cx="381000" cy="78771"/>
          </a:xfrm>
        </p:grpSpPr>
        <p:cxnSp>
          <p:nvCxnSpPr>
            <p:cNvPr id="127" name="Gerade Verbindung 126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Gerade Verbindung 127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Gerade Verbindung 12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7" name="Textfeld 236"/>
          <p:cNvSpPr txBox="1"/>
          <p:nvPr/>
        </p:nvSpPr>
        <p:spPr>
          <a:xfrm>
            <a:off x="4921306" y="31313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Nfix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Textfeld 237"/>
          <p:cNvSpPr txBox="1"/>
          <p:nvPr/>
        </p:nvSpPr>
        <p:spPr>
          <a:xfrm>
            <a:off x="5366036" y="646367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9" name="Gruppieren 238"/>
          <p:cNvGrpSpPr/>
          <p:nvPr/>
        </p:nvGrpSpPr>
        <p:grpSpPr>
          <a:xfrm>
            <a:off x="5338120" y="772221"/>
            <a:ext cx="348714" cy="86854"/>
            <a:chOff x="1447800" y="457200"/>
            <a:chExt cx="383732" cy="63312"/>
          </a:xfrm>
        </p:grpSpPr>
        <p:cxnSp>
          <p:nvCxnSpPr>
            <p:cNvPr id="240" name="Gerade Verbindung 239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Gerade Verbindung 240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Gerade Verbindung 24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3" name="Gruppieren 242"/>
          <p:cNvGrpSpPr/>
          <p:nvPr/>
        </p:nvGrpSpPr>
        <p:grpSpPr>
          <a:xfrm>
            <a:off x="5339444" y="631401"/>
            <a:ext cx="669905" cy="86293"/>
            <a:chOff x="2868920" y="5536746"/>
            <a:chExt cx="669905" cy="86293"/>
          </a:xfrm>
        </p:grpSpPr>
        <p:cxnSp>
          <p:nvCxnSpPr>
            <p:cNvPr id="244" name="Gerade Verbindung 24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Gerade Verbindung 244"/>
            <p:cNvCxnSpPr/>
            <p:nvPr/>
          </p:nvCxnSpPr>
          <p:spPr>
            <a:xfrm>
              <a:off x="3538344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Gerade Verbindung 24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7" name="Textfeld 246"/>
          <p:cNvSpPr txBox="1"/>
          <p:nvPr/>
        </p:nvSpPr>
        <p:spPr>
          <a:xfrm>
            <a:off x="5534400" y="50485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8" name="Textfeld 247"/>
          <p:cNvSpPr txBox="1"/>
          <p:nvPr/>
        </p:nvSpPr>
        <p:spPr>
          <a:xfrm>
            <a:off x="5692704" y="346591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grpSp>
        <p:nvGrpSpPr>
          <p:cNvPr id="249" name="Gruppieren 248"/>
          <p:cNvGrpSpPr/>
          <p:nvPr/>
        </p:nvGrpSpPr>
        <p:grpSpPr>
          <a:xfrm>
            <a:off x="5336251" y="471798"/>
            <a:ext cx="1017609" cy="87657"/>
            <a:chOff x="1447800" y="457200"/>
            <a:chExt cx="381000" cy="78771"/>
          </a:xfrm>
        </p:grpSpPr>
        <p:cxnSp>
          <p:nvCxnSpPr>
            <p:cNvPr id="250" name="Gerade Verbindung 249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Gerade Verbindung 250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Gerade Verbindung 25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3" name="Gruppieren 252"/>
          <p:cNvGrpSpPr/>
          <p:nvPr/>
        </p:nvGrpSpPr>
        <p:grpSpPr>
          <a:xfrm>
            <a:off x="5678931" y="264633"/>
            <a:ext cx="669905" cy="86293"/>
            <a:chOff x="2868920" y="5536746"/>
            <a:chExt cx="669905" cy="86293"/>
          </a:xfrm>
        </p:grpSpPr>
        <p:cxnSp>
          <p:nvCxnSpPr>
            <p:cNvPr id="254" name="Gerade Verbindung 25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Gerade Verbindung 254"/>
            <p:cNvCxnSpPr/>
            <p:nvPr/>
          </p:nvCxnSpPr>
          <p:spPr>
            <a:xfrm>
              <a:off x="3538344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Gerade Verbindung 25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7" name="Textfeld 256"/>
          <p:cNvSpPr txBox="1"/>
          <p:nvPr/>
        </p:nvSpPr>
        <p:spPr>
          <a:xfrm>
            <a:off x="5878911" y="148135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1" name="Textfeld 340"/>
          <p:cNvSpPr txBox="1"/>
          <p:nvPr/>
        </p:nvSpPr>
        <p:spPr>
          <a:xfrm>
            <a:off x="7099153" y="31313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Pde4d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2" name="Textfeld 341"/>
          <p:cNvSpPr txBox="1"/>
          <p:nvPr/>
        </p:nvSpPr>
        <p:spPr>
          <a:xfrm>
            <a:off x="7584514" y="572144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43" name="Gruppieren 342"/>
          <p:cNvGrpSpPr/>
          <p:nvPr/>
        </p:nvGrpSpPr>
        <p:grpSpPr>
          <a:xfrm>
            <a:off x="7534653" y="697998"/>
            <a:ext cx="348714" cy="86854"/>
            <a:chOff x="1447800" y="457200"/>
            <a:chExt cx="383732" cy="63312"/>
          </a:xfrm>
        </p:grpSpPr>
        <p:cxnSp>
          <p:nvCxnSpPr>
            <p:cNvPr id="344" name="Gerade Verbindung 343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" name="Gerade Verbindung 344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6" name="Gerade Verbindung 345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2" name="Textfeld 351"/>
          <p:cNvSpPr txBox="1"/>
          <p:nvPr/>
        </p:nvSpPr>
        <p:spPr>
          <a:xfrm>
            <a:off x="7889237" y="27320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grpSp>
        <p:nvGrpSpPr>
          <p:cNvPr id="353" name="Gruppieren 352"/>
          <p:cNvGrpSpPr/>
          <p:nvPr/>
        </p:nvGrpSpPr>
        <p:grpSpPr>
          <a:xfrm>
            <a:off x="7532784" y="398415"/>
            <a:ext cx="1025368" cy="87657"/>
            <a:chOff x="1447800" y="457200"/>
            <a:chExt cx="383905" cy="78771"/>
          </a:xfrm>
        </p:grpSpPr>
        <p:cxnSp>
          <p:nvCxnSpPr>
            <p:cNvPr id="354" name="Gerade Verbindung 353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Gerade Verbindung 354"/>
            <p:cNvCxnSpPr/>
            <p:nvPr/>
          </p:nvCxnSpPr>
          <p:spPr>
            <a:xfrm>
              <a:off x="183170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Gerade Verbindung 355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3" name="Textfeld 362"/>
          <p:cNvSpPr txBox="1"/>
          <p:nvPr/>
        </p:nvSpPr>
        <p:spPr>
          <a:xfrm>
            <a:off x="501706" y="2431276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Bsn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4" name="Textfeld 363"/>
          <p:cNvSpPr txBox="1"/>
          <p:nvPr/>
        </p:nvSpPr>
        <p:spPr>
          <a:xfrm>
            <a:off x="943065" y="2681952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65" name="Gruppieren 364"/>
          <p:cNvGrpSpPr/>
          <p:nvPr/>
        </p:nvGrpSpPr>
        <p:grpSpPr>
          <a:xfrm>
            <a:off x="918324" y="2807806"/>
            <a:ext cx="348714" cy="86854"/>
            <a:chOff x="1447800" y="457200"/>
            <a:chExt cx="383732" cy="63312"/>
          </a:xfrm>
        </p:grpSpPr>
        <p:cxnSp>
          <p:nvCxnSpPr>
            <p:cNvPr id="366" name="Gerade Verbindung 365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" name="Gerade Verbindung 366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8" name="Gerade Verbindung 367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9" name="Gruppieren 368"/>
          <p:cNvGrpSpPr/>
          <p:nvPr/>
        </p:nvGrpSpPr>
        <p:grpSpPr>
          <a:xfrm>
            <a:off x="916651" y="2633800"/>
            <a:ext cx="674448" cy="86293"/>
            <a:chOff x="2868920" y="5536746"/>
            <a:chExt cx="674448" cy="86293"/>
          </a:xfrm>
        </p:grpSpPr>
        <p:cxnSp>
          <p:nvCxnSpPr>
            <p:cNvPr id="370" name="Gerade Verbindung 369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" name="Gerade Verbindung 370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Gerade Verbindung 371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3" name="Textfeld 372"/>
          <p:cNvSpPr txBox="1"/>
          <p:nvPr/>
        </p:nvSpPr>
        <p:spPr>
          <a:xfrm>
            <a:off x="1111607" y="2507254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4" name="Textfeld 373"/>
          <p:cNvSpPr txBox="1"/>
          <p:nvPr/>
        </p:nvSpPr>
        <p:spPr>
          <a:xfrm>
            <a:off x="1273104" y="233680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75" name="Gruppieren 374"/>
          <p:cNvGrpSpPr/>
          <p:nvPr/>
        </p:nvGrpSpPr>
        <p:grpSpPr>
          <a:xfrm>
            <a:off x="916651" y="2462007"/>
            <a:ext cx="1017609" cy="87657"/>
            <a:chOff x="1447800" y="457200"/>
            <a:chExt cx="381000" cy="78771"/>
          </a:xfrm>
        </p:grpSpPr>
        <p:cxnSp>
          <p:nvCxnSpPr>
            <p:cNvPr id="376" name="Gerade Verbindung 375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" name="Gerade Verbindung 376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8" name="Gerade Verbindung 377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9" name="Textfeld 88"/>
          <p:cNvSpPr txBox="1"/>
          <p:nvPr/>
        </p:nvSpPr>
        <p:spPr>
          <a:xfrm>
            <a:off x="2713286" y="2434860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Spen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3138235" y="2593516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1" name="Gruppieren 90"/>
          <p:cNvGrpSpPr/>
          <p:nvPr/>
        </p:nvGrpSpPr>
        <p:grpSpPr>
          <a:xfrm>
            <a:off x="3113494" y="2719370"/>
            <a:ext cx="348714" cy="86854"/>
            <a:chOff x="1447800" y="457200"/>
            <a:chExt cx="383732" cy="63312"/>
          </a:xfrm>
        </p:grpSpPr>
        <p:cxnSp>
          <p:nvCxnSpPr>
            <p:cNvPr id="92" name="Gerade Verbindung 91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Gerade Verbindung 92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Gerade Verbindung 9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5" name="Gruppieren 94"/>
          <p:cNvGrpSpPr/>
          <p:nvPr/>
        </p:nvGrpSpPr>
        <p:grpSpPr>
          <a:xfrm>
            <a:off x="3111821" y="2545364"/>
            <a:ext cx="674448" cy="86293"/>
            <a:chOff x="2868920" y="5536746"/>
            <a:chExt cx="674448" cy="86293"/>
          </a:xfrm>
        </p:grpSpPr>
        <p:cxnSp>
          <p:nvCxnSpPr>
            <p:cNvPr id="96" name="Gerade Verbindung 95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Gerade Verbindung 96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Gerade Verbindung 97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9" name="Textfeld 98"/>
          <p:cNvSpPr txBox="1"/>
          <p:nvPr/>
        </p:nvSpPr>
        <p:spPr>
          <a:xfrm>
            <a:off x="3306777" y="241881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feld 99"/>
          <p:cNvSpPr txBox="1"/>
          <p:nvPr/>
        </p:nvSpPr>
        <p:spPr>
          <a:xfrm>
            <a:off x="3468274" y="2248364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1" name="Gruppieren 100"/>
          <p:cNvGrpSpPr/>
          <p:nvPr/>
        </p:nvGrpSpPr>
        <p:grpSpPr>
          <a:xfrm>
            <a:off x="3111821" y="2373571"/>
            <a:ext cx="1017609" cy="87657"/>
            <a:chOff x="1447800" y="457200"/>
            <a:chExt cx="381000" cy="78771"/>
          </a:xfrm>
        </p:grpSpPr>
        <p:cxnSp>
          <p:nvCxnSpPr>
            <p:cNvPr id="102" name="Gerade Verbindung 101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Gerade Verbindung 102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Gerade Verbindung 103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6" name="Textfeld 105"/>
          <p:cNvSpPr txBox="1"/>
          <p:nvPr/>
        </p:nvSpPr>
        <p:spPr>
          <a:xfrm>
            <a:off x="4911286" y="2434860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Lmna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5362665" y="2594705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8" name="Gruppieren 107"/>
          <p:cNvGrpSpPr/>
          <p:nvPr/>
        </p:nvGrpSpPr>
        <p:grpSpPr>
          <a:xfrm>
            <a:off x="5337924" y="2720559"/>
            <a:ext cx="348714" cy="86854"/>
            <a:chOff x="1447800" y="457200"/>
            <a:chExt cx="383732" cy="63312"/>
          </a:xfrm>
        </p:grpSpPr>
        <p:cxnSp>
          <p:nvCxnSpPr>
            <p:cNvPr id="109" name="Gerade Verbindung 10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Gerade Verbindung 109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Gerade Verbindung 11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Gruppieren 111"/>
          <p:cNvGrpSpPr/>
          <p:nvPr/>
        </p:nvGrpSpPr>
        <p:grpSpPr>
          <a:xfrm>
            <a:off x="5336251" y="2546553"/>
            <a:ext cx="674448" cy="86293"/>
            <a:chOff x="2868920" y="5536746"/>
            <a:chExt cx="674448" cy="86293"/>
          </a:xfrm>
        </p:grpSpPr>
        <p:cxnSp>
          <p:nvCxnSpPr>
            <p:cNvPr id="113" name="Gerade Verbindung 112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Gerade Verbindung 129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Gerade Verbindung 130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Textfeld 131"/>
          <p:cNvSpPr txBox="1"/>
          <p:nvPr/>
        </p:nvSpPr>
        <p:spPr>
          <a:xfrm>
            <a:off x="5546264" y="2420007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3" name="Gruppieren 132"/>
          <p:cNvGrpSpPr/>
          <p:nvPr/>
        </p:nvGrpSpPr>
        <p:grpSpPr>
          <a:xfrm>
            <a:off x="5336251" y="2374760"/>
            <a:ext cx="1017609" cy="87657"/>
            <a:chOff x="1447800" y="457200"/>
            <a:chExt cx="381000" cy="78771"/>
          </a:xfrm>
        </p:grpSpPr>
        <p:cxnSp>
          <p:nvCxnSpPr>
            <p:cNvPr id="134" name="Gerade Verbindung 133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Gerade Verbindung 134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Gerade Verbindung 135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7" name="Textfeld 136"/>
          <p:cNvSpPr txBox="1"/>
          <p:nvPr/>
        </p:nvSpPr>
        <p:spPr>
          <a:xfrm>
            <a:off x="5742438" y="2248998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feld 137"/>
          <p:cNvSpPr txBox="1"/>
          <p:nvPr/>
        </p:nvSpPr>
        <p:spPr>
          <a:xfrm>
            <a:off x="7120899" y="2429574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err="1" smtClean="0">
                <a:latin typeface="Arial" pitchFamily="34" charset="0"/>
                <a:cs typeface="Arial" pitchFamily="34" charset="0"/>
              </a:rPr>
              <a:t>Ptrf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7" name="Textfeld 316"/>
          <p:cNvSpPr txBox="1"/>
          <p:nvPr/>
        </p:nvSpPr>
        <p:spPr>
          <a:xfrm>
            <a:off x="2693430" y="456195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Cxcl14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23" name="Gruppieren 322"/>
          <p:cNvGrpSpPr/>
          <p:nvPr/>
        </p:nvGrpSpPr>
        <p:grpSpPr>
          <a:xfrm>
            <a:off x="3118947" y="5536746"/>
            <a:ext cx="674448" cy="86293"/>
            <a:chOff x="2868920" y="5536746"/>
            <a:chExt cx="674448" cy="86293"/>
          </a:xfrm>
        </p:grpSpPr>
        <p:cxnSp>
          <p:nvCxnSpPr>
            <p:cNvPr id="324" name="Gerade Verbindung 323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Gerade Verbindung 324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Gerade Verbindung 325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7" name="Textfeld 326"/>
          <p:cNvSpPr txBox="1"/>
          <p:nvPr/>
        </p:nvSpPr>
        <p:spPr>
          <a:xfrm>
            <a:off x="3313903" y="5410200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8" name="Textfeld 327"/>
          <p:cNvSpPr txBox="1"/>
          <p:nvPr/>
        </p:nvSpPr>
        <p:spPr>
          <a:xfrm>
            <a:off x="3485972" y="5045058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29" name="Gruppieren 328"/>
          <p:cNvGrpSpPr/>
          <p:nvPr/>
        </p:nvGrpSpPr>
        <p:grpSpPr>
          <a:xfrm>
            <a:off x="3118947" y="5170265"/>
            <a:ext cx="1017609" cy="87657"/>
            <a:chOff x="1447800" y="457200"/>
            <a:chExt cx="381000" cy="78771"/>
          </a:xfrm>
        </p:grpSpPr>
        <p:cxnSp>
          <p:nvCxnSpPr>
            <p:cNvPr id="330" name="Gerade Verbindung 329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Gerade Verbindung 330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Gerade Verbindung 331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3" name="Textfeld 332"/>
          <p:cNvSpPr txBox="1"/>
          <p:nvPr/>
        </p:nvSpPr>
        <p:spPr>
          <a:xfrm>
            <a:off x="501706" y="456195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Zfp574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4" name="Textfeld 333"/>
          <p:cNvSpPr txBox="1"/>
          <p:nvPr/>
        </p:nvSpPr>
        <p:spPr>
          <a:xfrm>
            <a:off x="4910712" y="456195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Robo3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5" name="Textfeld 334"/>
          <p:cNvSpPr txBox="1"/>
          <p:nvPr/>
        </p:nvSpPr>
        <p:spPr>
          <a:xfrm>
            <a:off x="5339729" y="4958579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6" name="Gruppieren 335"/>
          <p:cNvGrpSpPr/>
          <p:nvPr/>
        </p:nvGrpSpPr>
        <p:grpSpPr>
          <a:xfrm>
            <a:off x="5328222" y="5088566"/>
            <a:ext cx="348714" cy="86854"/>
            <a:chOff x="1447800" y="457200"/>
            <a:chExt cx="383732" cy="63312"/>
          </a:xfrm>
        </p:grpSpPr>
        <p:cxnSp>
          <p:nvCxnSpPr>
            <p:cNvPr id="337" name="Gerade Verbindung 336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Gerade Verbindung 337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Gerade Verbindung 338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0" name="Gruppieren 339"/>
          <p:cNvGrpSpPr/>
          <p:nvPr/>
        </p:nvGrpSpPr>
        <p:grpSpPr>
          <a:xfrm>
            <a:off x="5328222" y="4937444"/>
            <a:ext cx="674448" cy="86293"/>
            <a:chOff x="2868920" y="5536746"/>
            <a:chExt cx="674448" cy="86293"/>
          </a:xfrm>
        </p:grpSpPr>
        <p:cxnSp>
          <p:nvCxnSpPr>
            <p:cNvPr id="347" name="Gerade Verbindung 346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Gerade Verbindung 347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9" name="Gerade Verbindung 348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0" name="Textfeld 349"/>
          <p:cNvSpPr txBox="1"/>
          <p:nvPr/>
        </p:nvSpPr>
        <p:spPr>
          <a:xfrm>
            <a:off x="5523178" y="481089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1" name="Textfeld 350"/>
          <p:cNvSpPr txBox="1"/>
          <p:nvPr/>
        </p:nvSpPr>
        <p:spPr>
          <a:xfrm>
            <a:off x="5661678" y="4675008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57" name="Gruppieren 356"/>
          <p:cNvGrpSpPr/>
          <p:nvPr/>
        </p:nvGrpSpPr>
        <p:grpSpPr>
          <a:xfrm>
            <a:off x="5331103" y="4800215"/>
            <a:ext cx="1017609" cy="87657"/>
            <a:chOff x="1447800" y="457200"/>
            <a:chExt cx="381000" cy="78771"/>
          </a:xfrm>
        </p:grpSpPr>
        <p:cxnSp>
          <p:nvCxnSpPr>
            <p:cNvPr id="358" name="Gerade Verbindung 357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Gerade Verbindung 358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Gerade Verbindung 35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1" name="Gruppieren 360"/>
          <p:cNvGrpSpPr/>
          <p:nvPr/>
        </p:nvGrpSpPr>
        <p:grpSpPr>
          <a:xfrm>
            <a:off x="5677444" y="4650588"/>
            <a:ext cx="674448" cy="86293"/>
            <a:chOff x="2868920" y="5536746"/>
            <a:chExt cx="674448" cy="86293"/>
          </a:xfrm>
        </p:grpSpPr>
        <p:cxnSp>
          <p:nvCxnSpPr>
            <p:cNvPr id="362" name="Gerade Verbindung 361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9" name="Gerade Verbindung 378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Gerade Verbindung 379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1" name="Textfeld 380"/>
          <p:cNvSpPr txBox="1"/>
          <p:nvPr/>
        </p:nvSpPr>
        <p:spPr>
          <a:xfrm>
            <a:off x="5872400" y="4524042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82" name="Gruppieren 381"/>
          <p:cNvGrpSpPr/>
          <p:nvPr/>
        </p:nvGrpSpPr>
        <p:grpSpPr>
          <a:xfrm>
            <a:off x="6003178" y="4448542"/>
            <a:ext cx="348714" cy="86854"/>
            <a:chOff x="1447800" y="457200"/>
            <a:chExt cx="383732" cy="63312"/>
          </a:xfrm>
        </p:grpSpPr>
        <p:cxnSp>
          <p:nvCxnSpPr>
            <p:cNvPr id="383" name="Gerade Verbindung 382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4" name="Gerade Verbindung 383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5" name="Gerade Verbindung 384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6" name="Textfeld 385"/>
          <p:cNvSpPr txBox="1"/>
          <p:nvPr/>
        </p:nvSpPr>
        <p:spPr>
          <a:xfrm>
            <a:off x="6064609" y="4317924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7" name="Textfeld 386"/>
          <p:cNvSpPr txBox="1"/>
          <p:nvPr/>
        </p:nvSpPr>
        <p:spPr>
          <a:xfrm>
            <a:off x="7547885" y="5451815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88" name="Gruppieren 387"/>
          <p:cNvGrpSpPr/>
          <p:nvPr/>
        </p:nvGrpSpPr>
        <p:grpSpPr>
          <a:xfrm>
            <a:off x="7536776" y="5565181"/>
            <a:ext cx="348714" cy="86854"/>
            <a:chOff x="1447800" y="457200"/>
            <a:chExt cx="383732" cy="63312"/>
          </a:xfrm>
        </p:grpSpPr>
        <p:cxnSp>
          <p:nvCxnSpPr>
            <p:cNvPr id="389" name="Gerade Verbindung 388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Gerade Verbindung 389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1" name="Gerade Verbindung 39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2" name="Gruppieren 391"/>
          <p:cNvGrpSpPr/>
          <p:nvPr/>
        </p:nvGrpSpPr>
        <p:grpSpPr>
          <a:xfrm>
            <a:off x="7537670" y="5332620"/>
            <a:ext cx="674448" cy="86293"/>
            <a:chOff x="2868920" y="5536746"/>
            <a:chExt cx="674448" cy="86293"/>
          </a:xfrm>
        </p:grpSpPr>
        <p:cxnSp>
          <p:nvCxnSpPr>
            <p:cNvPr id="393" name="Gerade Verbindung 392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" name="Gerade Verbindung 393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" name="Gerade Verbindung 394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6" name="Textfeld 395"/>
          <p:cNvSpPr txBox="1"/>
          <p:nvPr/>
        </p:nvSpPr>
        <p:spPr>
          <a:xfrm>
            <a:off x="7732626" y="5206074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7" name="Textfeld 396"/>
          <p:cNvSpPr txBox="1"/>
          <p:nvPr/>
        </p:nvSpPr>
        <p:spPr>
          <a:xfrm>
            <a:off x="7864388" y="4979434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98" name="Gruppieren 397"/>
          <p:cNvGrpSpPr/>
          <p:nvPr/>
        </p:nvGrpSpPr>
        <p:grpSpPr>
          <a:xfrm>
            <a:off x="7533813" y="5104641"/>
            <a:ext cx="1017609" cy="87657"/>
            <a:chOff x="1447800" y="457200"/>
            <a:chExt cx="381000" cy="78771"/>
          </a:xfrm>
        </p:grpSpPr>
        <p:cxnSp>
          <p:nvCxnSpPr>
            <p:cNvPr id="399" name="Gerade Verbindung 398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0" name="Gerade Verbindung 399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1" name="Gerade Verbindung 400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2" name="Gruppieren 401"/>
          <p:cNvGrpSpPr/>
          <p:nvPr/>
        </p:nvGrpSpPr>
        <p:grpSpPr>
          <a:xfrm>
            <a:off x="7891500" y="4894632"/>
            <a:ext cx="674448" cy="86293"/>
            <a:chOff x="2868920" y="5536746"/>
            <a:chExt cx="674448" cy="86293"/>
          </a:xfrm>
        </p:grpSpPr>
        <p:cxnSp>
          <p:nvCxnSpPr>
            <p:cNvPr id="403" name="Gerade Verbindung 402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Gerade Verbindung 403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Gerade Verbindung 404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6" name="Textfeld 405"/>
          <p:cNvSpPr txBox="1"/>
          <p:nvPr/>
        </p:nvSpPr>
        <p:spPr>
          <a:xfrm>
            <a:off x="8070598" y="4768086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07" name="Gruppieren 406"/>
          <p:cNvGrpSpPr/>
          <p:nvPr/>
        </p:nvGrpSpPr>
        <p:grpSpPr>
          <a:xfrm>
            <a:off x="8224405" y="4686044"/>
            <a:ext cx="348714" cy="86854"/>
            <a:chOff x="1447800" y="457200"/>
            <a:chExt cx="383732" cy="63312"/>
          </a:xfrm>
        </p:grpSpPr>
        <p:cxnSp>
          <p:nvCxnSpPr>
            <p:cNvPr id="408" name="Gerade Verbindung 407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" name="Gerade Verbindung 408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" name="Gerade Verbindung 40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1" name="Textfeld 410"/>
          <p:cNvSpPr txBox="1"/>
          <p:nvPr/>
        </p:nvSpPr>
        <p:spPr>
          <a:xfrm>
            <a:off x="8291451" y="4575340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2" name="Textfeld 411"/>
          <p:cNvSpPr txBox="1"/>
          <p:nvPr/>
        </p:nvSpPr>
        <p:spPr>
          <a:xfrm>
            <a:off x="7144746" y="4561952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Prdm16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839"/>
          <a:stretch/>
        </p:blipFill>
        <p:spPr bwMode="auto">
          <a:xfrm>
            <a:off x="381000" y="541816"/>
            <a:ext cx="1774967" cy="1104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758"/>
          <a:stretch/>
        </p:blipFill>
        <p:spPr bwMode="auto">
          <a:xfrm>
            <a:off x="2587768" y="540224"/>
            <a:ext cx="1774967" cy="11056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758"/>
          <a:stretch/>
        </p:blipFill>
        <p:spPr bwMode="auto">
          <a:xfrm>
            <a:off x="4794891" y="540224"/>
            <a:ext cx="1774967" cy="11056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758"/>
          <a:stretch/>
        </p:blipFill>
        <p:spPr bwMode="auto">
          <a:xfrm>
            <a:off x="7003496" y="540224"/>
            <a:ext cx="1774967" cy="11056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635"/>
          <a:stretch/>
        </p:blipFill>
        <p:spPr bwMode="auto">
          <a:xfrm>
            <a:off x="383169" y="2667000"/>
            <a:ext cx="1774968" cy="1108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635"/>
          <a:stretch/>
        </p:blipFill>
        <p:spPr bwMode="auto">
          <a:xfrm>
            <a:off x="2587768" y="2667000"/>
            <a:ext cx="1774968" cy="1108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635"/>
          <a:stretch/>
        </p:blipFill>
        <p:spPr bwMode="auto">
          <a:xfrm>
            <a:off x="4794891" y="2667000"/>
            <a:ext cx="1774967" cy="1108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635"/>
          <a:stretch/>
        </p:blipFill>
        <p:spPr bwMode="auto">
          <a:xfrm>
            <a:off x="7003496" y="2667000"/>
            <a:ext cx="1774967" cy="1108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44355"/>
          <a:stretch/>
        </p:blipFill>
        <p:spPr bwMode="auto">
          <a:xfrm>
            <a:off x="383169" y="4790028"/>
            <a:ext cx="1776089" cy="1093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356"/>
          <a:stretch/>
        </p:blipFill>
        <p:spPr bwMode="auto">
          <a:xfrm>
            <a:off x="2587768" y="4790028"/>
            <a:ext cx="1774968" cy="1093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356"/>
          <a:stretch/>
        </p:blipFill>
        <p:spPr bwMode="auto">
          <a:xfrm>
            <a:off x="4794891" y="4790028"/>
            <a:ext cx="1774967" cy="1093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91" name="Gruppieren 190"/>
          <p:cNvGrpSpPr/>
          <p:nvPr/>
        </p:nvGrpSpPr>
        <p:grpSpPr>
          <a:xfrm>
            <a:off x="236551" y="1423947"/>
            <a:ext cx="1509388" cy="1005403"/>
            <a:chOff x="232874" y="1419259"/>
            <a:chExt cx="1509388" cy="1005403"/>
          </a:xfrm>
        </p:grpSpPr>
        <p:sp>
          <p:nvSpPr>
            <p:cNvPr id="192" name="Textfeld 191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193" name="Rechteck 192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" name="Rechteck 193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5" name="Rechteck 194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96" name="Gruppieren 195"/>
          <p:cNvGrpSpPr/>
          <p:nvPr/>
        </p:nvGrpSpPr>
        <p:grpSpPr>
          <a:xfrm>
            <a:off x="2453012" y="1423947"/>
            <a:ext cx="1509388" cy="1005403"/>
            <a:chOff x="232874" y="1419259"/>
            <a:chExt cx="1509388" cy="1005403"/>
          </a:xfrm>
        </p:grpSpPr>
        <p:sp>
          <p:nvSpPr>
            <p:cNvPr id="197" name="Textfeld 196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198" name="Rechteck 197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Rechteck 198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Rechteck 199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1" name="Gruppieren 200"/>
          <p:cNvGrpSpPr/>
          <p:nvPr/>
        </p:nvGrpSpPr>
        <p:grpSpPr>
          <a:xfrm>
            <a:off x="4664102" y="1423947"/>
            <a:ext cx="1509388" cy="1005403"/>
            <a:chOff x="232874" y="1419259"/>
            <a:chExt cx="1509388" cy="1005403"/>
          </a:xfrm>
        </p:grpSpPr>
        <p:sp>
          <p:nvSpPr>
            <p:cNvPr id="202" name="Textfeld 201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7)</a:t>
              </a:r>
            </a:p>
          </p:txBody>
        </p:sp>
        <p:sp>
          <p:nvSpPr>
            <p:cNvPr id="203" name="Rechteck 202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" name="Rechteck 203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" name="Rechteck 204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6" name="Gruppieren 205"/>
          <p:cNvGrpSpPr/>
          <p:nvPr/>
        </p:nvGrpSpPr>
        <p:grpSpPr>
          <a:xfrm>
            <a:off x="6865951" y="1423947"/>
            <a:ext cx="1509388" cy="1005403"/>
            <a:chOff x="232874" y="1419259"/>
            <a:chExt cx="1509388" cy="1005403"/>
          </a:xfrm>
        </p:grpSpPr>
        <p:sp>
          <p:nvSpPr>
            <p:cNvPr id="207" name="Textfeld 206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4)</a:t>
              </a:r>
            </a:p>
          </p:txBody>
        </p:sp>
        <p:sp>
          <p:nvSpPr>
            <p:cNvPr id="208" name="Rechteck 207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Rechteck 208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3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" name="Rechteck 209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11" name="Gruppieren 210"/>
          <p:cNvGrpSpPr/>
          <p:nvPr/>
        </p:nvGrpSpPr>
        <p:grpSpPr>
          <a:xfrm>
            <a:off x="6865951" y="3564449"/>
            <a:ext cx="1509388" cy="1005403"/>
            <a:chOff x="232874" y="1419259"/>
            <a:chExt cx="1509388" cy="1005403"/>
          </a:xfrm>
        </p:grpSpPr>
        <p:sp>
          <p:nvSpPr>
            <p:cNvPr id="212" name="Textfeld 211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13" name="Rechteck 212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Rechteck 213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" name="Rechteck 214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16" name="Gruppieren 215"/>
          <p:cNvGrpSpPr/>
          <p:nvPr/>
        </p:nvGrpSpPr>
        <p:grpSpPr>
          <a:xfrm>
            <a:off x="4664102" y="3564449"/>
            <a:ext cx="1509388" cy="1005403"/>
            <a:chOff x="232874" y="1419259"/>
            <a:chExt cx="1509388" cy="1005403"/>
          </a:xfrm>
        </p:grpSpPr>
        <p:sp>
          <p:nvSpPr>
            <p:cNvPr id="217" name="Textfeld 216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6)</a:t>
              </a:r>
            </a:p>
          </p:txBody>
        </p:sp>
        <p:sp>
          <p:nvSpPr>
            <p:cNvPr id="218" name="Rechteck 217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" name="Rechteck 218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3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" name="Rechteck 219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21" name="Gruppieren 220"/>
          <p:cNvGrpSpPr/>
          <p:nvPr/>
        </p:nvGrpSpPr>
        <p:grpSpPr>
          <a:xfrm>
            <a:off x="2453012" y="3564449"/>
            <a:ext cx="1509388" cy="1005403"/>
            <a:chOff x="232874" y="1419259"/>
            <a:chExt cx="1509388" cy="1005403"/>
          </a:xfrm>
        </p:grpSpPr>
        <p:sp>
          <p:nvSpPr>
            <p:cNvPr id="222" name="Textfeld 221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23" name="Rechteck 222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" name="Rechteck 223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" name="Rechteck 224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26" name="Gruppieren 225"/>
          <p:cNvGrpSpPr/>
          <p:nvPr/>
        </p:nvGrpSpPr>
        <p:grpSpPr>
          <a:xfrm>
            <a:off x="236551" y="3564449"/>
            <a:ext cx="1509388" cy="1005403"/>
            <a:chOff x="232874" y="1419259"/>
            <a:chExt cx="1509388" cy="1005403"/>
          </a:xfrm>
        </p:grpSpPr>
        <p:sp>
          <p:nvSpPr>
            <p:cNvPr id="227" name="Textfeld 226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28" name="Rechteck 227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" name="Rechteck 228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0" name="Rechteck 229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1" name="Gruppieren 230"/>
          <p:cNvGrpSpPr/>
          <p:nvPr/>
        </p:nvGrpSpPr>
        <p:grpSpPr>
          <a:xfrm>
            <a:off x="236551" y="5685223"/>
            <a:ext cx="1509388" cy="1005403"/>
            <a:chOff x="232874" y="1419259"/>
            <a:chExt cx="1509388" cy="1005403"/>
          </a:xfrm>
        </p:grpSpPr>
        <p:sp>
          <p:nvSpPr>
            <p:cNvPr id="232" name="Textfeld 231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33" name="Rechteck 232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4" name="Rechteck 233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5" name="Rechteck 234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6" name="Gruppieren 235"/>
          <p:cNvGrpSpPr/>
          <p:nvPr/>
        </p:nvGrpSpPr>
        <p:grpSpPr>
          <a:xfrm>
            <a:off x="2453012" y="5685223"/>
            <a:ext cx="1509388" cy="1005403"/>
            <a:chOff x="232874" y="1419259"/>
            <a:chExt cx="1509388" cy="1005403"/>
          </a:xfrm>
        </p:grpSpPr>
        <p:sp>
          <p:nvSpPr>
            <p:cNvPr id="258" name="Textfeld 257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59" name="Rechteck 258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Rechteck 259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1" name="Rechteck 260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2" name="Gruppieren 261"/>
          <p:cNvGrpSpPr/>
          <p:nvPr/>
        </p:nvGrpSpPr>
        <p:grpSpPr>
          <a:xfrm>
            <a:off x="4664102" y="5685223"/>
            <a:ext cx="1509388" cy="1005403"/>
            <a:chOff x="232874" y="1419259"/>
            <a:chExt cx="1509388" cy="1005403"/>
          </a:xfrm>
        </p:grpSpPr>
        <p:sp>
          <p:nvSpPr>
            <p:cNvPr id="263" name="Textfeld 262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264" name="Rechteck 263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Rechteck 264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Rechteck 265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7" name="Gruppieren 266"/>
          <p:cNvGrpSpPr/>
          <p:nvPr/>
        </p:nvGrpSpPr>
        <p:grpSpPr>
          <a:xfrm>
            <a:off x="6865951" y="5685223"/>
            <a:ext cx="1509388" cy="1005403"/>
            <a:chOff x="232874" y="1419259"/>
            <a:chExt cx="1509388" cy="1005403"/>
          </a:xfrm>
        </p:grpSpPr>
        <p:sp>
          <p:nvSpPr>
            <p:cNvPr id="268" name="Textfeld 267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269" name="Rechteck 268"/>
            <p:cNvSpPr/>
            <p:nvPr/>
          </p:nvSpPr>
          <p:spPr>
            <a:xfrm rot="18885091">
              <a:off x="532652" y="17818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0" name="Rechteck 269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4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Rechteck 270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247626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06866" y="308877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Il17rc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892837" y="1045571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Gruppieren 6"/>
          <p:cNvGrpSpPr/>
          <p:nvPr/>
        </p:nvGrpSpPr>
        <p:grpSpPr>
          <a:xfrm>
            <a:off x="881330" y="1175558"/>
            <a:ext cx="348714" cy="86854"/>
            <a:chOff x="1447800" y="457200"/>
            <a:chExt cx="383732" cy="63312"/>
          </a:xfrm>
        </p:grpSpPr>
        <p:cxnSp>
          <p:nvCxnSpPr>
            <p:cNvPr id="8" name="Gerade Verbindung 7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 Verbindung 8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Gerade Verbindung 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uppieren 10"/>
          <p:cNvGrpSpPr/>
          <p:nvPr/>
        </p:nvGrpSpPr>
        <p:grpSpPr>
          <a:xfrm>
            <a:off x="881330" y="1024436"/>
            <a:ext cx="674448" cy="86293"/>
            <a:chOff x="2868920" y="5536746"/>
            <a:chExt cx="674448" cy="86293"/>
          </a:xfrm>
        </p:grpSpPr>
        <p:cxnSp>
          <p:nvCxnSpPr>
            <p:cNvPr id="12" name="Gerade Verbindung 11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12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 Verbindung 13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feld 14"/>
          <p:cNvSpPr txBox="1"/>
          <p:nvPr/>
        </p:nvSpPr>
        <p:spPr>
          <a:xfrm>
            <a:off x="1076286" y="897890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278394" y="76200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Gruppieren 16"/>
          <p:cNvGrpSpPr/>
          <p:nvPr/>
        </p:nvGrpSpPr>
        <p:grpSpPr>
          <a:xfrm>
            <a:off x="884211" y="887208"/>
            <a:ext cx="1063859" cy="82336"/>
            <a:chOff x="1447800" y="457200"/>
            <a:chExt cx="381000" cy="78771"/>
          </a:xfrm>
        </p:grpSpPr>
        <p:cxnSp>
          <p:nvCxnSpPr>
            <p:cNvPr id="18" name="Gerade Verbindung 17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18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19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052"/>
          <a:stretch/>
        </p:blipFill>
        <p:spPr bwMode="auto">
          <a:xfrm>
            <a:off x="387253" y="538889"/>
            <a:ext cx="1774968" cy="10999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178"/>
          <a:stretch/>
        </p:blipFill>
        <p:spPr bwMode="auto">
          <a:xfrm>
            <a:off x="2590800" y="541351"/>
            <a:ext cx="1774968" cy="1097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2" name="Textfeld 131"/>
          <p:cNvSpPr txBox="1"/>
          <p:nvPr/>
        </p:nvSpPr>
        <p:spPr>
          <a:xfrm>
            <a:off x="2732568" y="312751"/>
            <a:ext cx="620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i="1" dirty="0" smtClean="0">
                <a:latin typeface="Arial" pitchFamily="34" charset="0"/>
                <a:cs typeface="Arial" pitchFamily="34" charset="0"/>
              </a:rPr>
              <a:t>Tcp11</a:t>
            </a:r>
            <a:endParaRPr lang="de-DE" sz="9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feld 132"/>
          <p:cNvSpPr txBox="1"/>
          <p:nvPr/>
        </p:nvSpPr>
        <p:spPr>
          <a:xfrm>
            <a:off x="3123175" y="950159"/>
            <a:ext cx="3462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4" name="Gruppieren 133"/>
          <p:cNvGrpSpPr/>
          <p:nvPr/>
        </p:nvGrpSpPr>
        <p:grpSpPr>
          <a:xfrm>
            <a:off x="3111668" y="1080146"/>
            <a:ext cx="348714" cy="86854"/>
            <a:chOff x="1447800" y="457200"/>
            <a:chExt cx="383732" cy="63312"/>
          </a:xfrm>
        </p:grpSpPr>
        <p:cxnSp>
          <p:nvCxnSpPr>
            <p:cNvPr id="135" name="Gerade Verbindung 134"/>
            <p:cNvCxnSpPr/>
            <p:nvPr/>
          </p:nvCxnSpPr>
          <p:spPr>
            <a:xfrm>
              <a:off x="1447800" y="457200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Gerade Verbindung 135"/>
            <p:cNvCxnSpPr/>
            <p:nvPr/>
          </p:nvCxnSpPr>
          <p:spPr>
            <a:xfrm>
              <a:off x="1831532" y="458804"/>
              <a:ext cx="0" cy="6170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Gerade Verbindung 13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" name="Gruppieren 137"/>
          <p:cNvGrpSpPr/>
          <p:nvPr/>
        </p:nvGrpSpPr>
        <p:grpSpPr>
          <a:xfrm>
            <a:off x="3111668" y="929024"/>
            <a:ext cx="674448" cy="86293"/>
            <a:chOff x="2868920" y="5536746"/>
            <a:chExt cx="674448" cy="86293"/>
          </a:xfrm>
        </p:grpSpPr>
        <p:cxnSp>
          <p:nvCxnSpPr>
            <p:cNvPr id="139" name="Gerade Verbindung 138"/>
            <p:cNvCxnSpPr/>
            <p:nvPr/>
          </p:nvCxnSpPr>
          <p:spPr>
            <a:xfrm>
              <a:off x="2868920" y="5536746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Gerade Verbindung 139"/>
            <p:cNvCxnSpPr/>
            <p:nvPr/>
          </p:nvCxnSpPr>
          <p:spPr>
            <a:xfrm>
              <a:off x="3543368" y="5540743"/>
              <a:ext cx="0" cy="82296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Gerade Verbindung 140"/>
            <p:cNvCxnSpPr/>
            <p:nvPr/>
          </p:nvCxnSpPr>
          <p:spPr>
            <a:xfrm flipH="1">
              <a:off x="2868920" y="5536746"/>
              <a:ext cx="669905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2" name="Textfeld 141"/>
          <p:cNvSpPr txBox="1"/>
          <p:nvPr/>
        </p:nvSpPr>
        <p:spPr>
          <a:xfrm>
            <a:off x="3298673" y="80247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Textfeld 142"/>
          <p:cNvSpPr txBox="1"/>
          <p:nvPr/>
        </p:nvSpPr>
        <p:spPr>
          <a:xfrm>
            <a:off x="3524634" y="666588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*</a:t>
            </a:r>
          </a:p>
          <a:p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4" name="Gruppieren 143"/>
          <p:cNvGrpSpPr/>
          <p:nvPr/>
        </p:nvGrpSpPr>
        <p:grpSpPr>
          <a:xfrm>
            <a:off x="3114550" y="791795"/>
            <a:ext cx="1036032" cy="90801"/>
            <a:chOff x="1447800" y="457200"/>
            <a:chExt cx="381000" cy="78771"/>
          </a:xfrm>
        </p:grpSpPr>
        <p:cxnSp>
          <p:nvCxnSpPr>
            <p:cNvPr id="145" name="Gerade Verbindung 144"/>
            <p:cNvCxnSpPr/>
            <p:nvPr/>
          </p:nvCxnSpPr>
          <p:spPr>
            <a:xfrm>
              <a:off x="1447800" y="457200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Gerade Verbindung 145"/>
            <p:cNvCxnSpPr/>
            <p:nvPr/>
          </p:nvCxnSpPr>
          <p:spPr>
            <a:xfrm>
              <a:off x="1828475" y="459771"/>
              <a:ext cx="0" cy="762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Gerade Verbindung 146"/>
            <p:cNvCxnSpPr/>
            <p:nvPr/>
          </p:nvCxnSpPr>
          <p:spPr>
            <a:xfrm flipH="1">
              <a:off x="1447800" y="457200"/>
              <a:ext cx="381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uppieren 35"/>
          <p:cNvGrpSpPr/>
          <p:nvPr/>
        </p:nvGrpSpPr>
        <p:grpSpPr>
          <a:xfrm>
            <a:off x="252352" y="1401290"/>
            <a:ext cx="1509388" cy="1005403"/>
            <a:chOff x="232874" y="1419259"/>
            <a:chExt cx="1509388" cy="1005403"/>
          </a:xfrm>
        </p:grpSpPr>
        <p:sp>
          <p:nvSpPr>
            <p:cNvPr id="37" name="Textfeld 36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38" name="Rechteck 37"/>
            <p:cNvSpPr/>
            <p:nvPr/>
          </p:nvSpPr>
          <p:spPr>
            <a:xfrm rot="18885091">
              <a:off x="512825" y="1793712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chteck 38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Rechteck 39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1" name="Gruppieren 40"/>
          <p:cNvGrpSpPr/>
          <p:nvPr/>
        </p:nvGrpSpPr>
        <p:grpSpPr>
          <a:xfrm>
            <a:off x="2456214" y="1407228"/>
            <a:ext cx="1509388" cy="1005403"/>
            <a:chOff x="232874" y="1419259"/>
            <a:chExt cx="1509388" cy="1005403"/>
          </a:xfrm>
        </p:grpSpPr>
        <p:sp>
          <p:nvSpPr>
            <p:cNvPr id="42" name="Textfeld 41"/>
            <p:cNvSpPr txBox="1"/>
            <p:nvPr/>
          </p:nvSpPr>
          <p:spPr>
            <a:xfrm rot="18974389">
              <a:off x="232874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8)</a:t>
              </a:r>
            </a:p>
          </p:txBody>
        </p:sp>
        <p:sp>
          <p:nvSpPr>
            <p:cNvPr id="43" name="Rechteck 42"/>
            <p:cNvSpPr/>
            <p:nvPr/>
          </p:nvSpPr>
          <p:spPr>
            <a:xfrm rot="18885091">
              <a:off x="512825" y="1793712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hteck 43"/>
            <p:cNvSpPr/>
            <p:nvPr/>
          </p:nvSpPr>
          <p:spPr>
            <a:xfrm rot="18885091">
              <a:off x="785919" y="182193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hteck 44"/>
            <p:cNvSpPr/>
            <p:nvPr/>
          </p:nvSpPr>
          <p:spPr>
            <a:xfrm rot="18885091">
              <a:off x="1153960" y="1811256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Rechteck 1"/>
          <p:cNvSpPr/>
          <p:nvPr/>
        </p:nvSpPr>
        <p:spPr>
          <a:xfrm>
            <a:off x="304800" y="2667000"/>
            <a:ext cx="8382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Arial" pitchFamily="34" charset="0"/>
                <a:cs typeface="Arial" pitchFamily="34" charset="0"/>
              </a:rPr>
              <a:t>Validation of array-based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screening results by quantitativ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DNA methylation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alysis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MassARRAY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. 40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releukemic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ypermethylated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genes were randomly selected for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MassARRAY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nalysis (see also Fig. 2 for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Fzd5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Fzd8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.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Dotplot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depict average methylation per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mplico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nd sample, the median of a sample group is represented by a black bar. Mann-Whitney U test was used to test for differences between wild type and the different disease stages and also between the disease stages (* p &lt; 0.05, ** p &lt; 0.01, *** p ≤ 0.001).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841222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6</Words>
  <Application>Microsoft Office PowerPoint</Application>
  <PresentationFormat>Bildschirmpräsentation (4:3)</PresentationFormat>
  <Paragraphs>316</Paragraphs>
  <Slides>4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Larissa</vt:lpstr>
      <vt:lpstr>PowerPoint-Präsentation</vt:lpstr>
      <vt:lpstr>PowerPoint-Präsentation</vt:lpstr>
      <vt:lpstr>PowerPoint-Präsentation</vt:lpstr>
      <vt:lpstr>PowerPoint-Präsentation</vt:lpstr>
    </vt:vector>
  </TitlesOfParts>
  <Company>DK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onnet</dc:creator>
  <cp:lastModifiedBy>sonnet</cp:lastModifiedBy>
  <cp:revision>120</cp:revision>
  <cp:lastPrinted>2013-01-10T14:51:14Z</cp:lastPrinted>
  <dcterms:created xsi:type="dcterms:W3CDTF">2013-01-10T13:28:25Z</dcterms:created>
  <dcterms:modified xsi:type="dcterms:W3CDTF">2013-03-26T09:32:30Z</dcterms:modified>
</cp:coreProperties>
</file>